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9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56" r:id="rId1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 snapToObjects="1">
      <p:cViewPr varScale="1">
        <p:scale>
          <a:sx n="96" d="100"/>
          <a:sy n="96" d="100"/>
        </p:scale>
        <p:origin x="114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https://ueanorwich-my.sharepoint.com/personal/xjj08xuu_uea_ac_uk/Documents/COB/Results/Figure%201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https://ueanorwich-my.sharepoint.com/personal/xjj08xuu_uea_ac_uk/Documents/COB/Results/Figure%201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https://qubstudentcloud-my.sharepoint.com/personal/3055689_ads_qub_ac_uk/Documents/COB/Results/Figure%201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https://qubstudentcloud-my.sharepoint.com/personal/3055689_ads_qub_ac_uk/Documents/COB/Results/Figure%201.xlsx" TargetMode="Externa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https://ueanorwich-my.sharepoint.com/personal/xjj08xuu_uea_ac_uk/Documents/COB/Results/Figure%20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https://ueanorwich-my.sharepoint.com/personal/xjj08xuu_uea_ac_uk/Documents/COB/Results/Figure%201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https://qubstudentcloud-my.sharepoint.com/personal/3055689_ads_qub_ac_uk/Documents/COB/Results/Figure%201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https://ueanorwich-my.sharepoint.com/personal/xjj08xuu_uea_ac_uk/Documents/COB/Results/Figure%201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https://qubstudentcloud-my.sharepoint.com/personal/3055689_ads_qub_ac_uk/Documents/COB/Results/Figure%201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https://ueanorwich-my.sharepoint.com/personal/xjj08xuu_uea_ac_uk/Documents/COB/Results/Figure%201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https://ueanorwich-my.sharepoint.com/personal/xjj08xuu_uea_ac_uk/Documents/COB/Results/Figure%201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https://qubstudentcloud-my.sharepoint.com/personal/3055689_ads_qub_ac_uk/Documents/COB/Results/Figure%201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https://ueanorwich-my.sharepoint.com/personal/xjj08xuu_uea_ac_uk/Documents/COB/Results/Figure%20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b="1"/>
              <a:t>Naringenin</a:t>
            </a: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0409953867867502"/>
          <c:y val="5.1549654467208252E-2"/>
          <c:w val="0.8137110249163827"/>
          <c:h val="0.83488085096061249"/>
        </c:manualLayout>
      </c:layout>
      <c:scatterChart>
        <c:scatterStyle val="smoothMarker"/>
        <c:varyColors val="0"/>
        <c:ser>
          <c:idx val="1"/>
          <c:order val="0"/>
          <c:tx>
            <c:strRef>
              <c:f>Data!$B$13</c:f>
              <c:strCache>
                <c:ptCount val="1"/>
                <c:pt idx="0">
                  <c:v>Older females</c:v>
                </c:pt>
              </c:strCache>
            </c:strRef>
          </c:tx>
          <c:spPr>
            <a:ln w="2222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squar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14:$A$17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B$14:$B$17</c:f>
              <c:numCache>
                <c:formatCode>General</c:formatCode>
                <c:ptCount val="4"/>
                <c:pt idx="0">
                  <c:v>1.1283694355365668E-2</c:v>
                </c:pt>
                <c:pt idx="1">
                  <c:v>5.0198308937297681E-2</c:v>
                </c:pt>
                <c:pt idx="2">
                  <c:v>8.819527883331911E-2</c:v>
                </c:pt>
                <c:pt idx="3">
                  <c:v>9.7225804887249079E-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8B54-2749-95FC-99C85457F744}"/>
            </c:ext>
          </c:extLst>
        </c:ser>
        <c:ser>
          <c:idx val="0"/>
          <c:order val="1"/>
          <c:tx>
            <c:strRef>
              <c:f>Data!$C$13</c:f>
              <c:strCache>
                <c:ptCount val="1"/>
                <c:pt idx="0">
                  <c:v>Older males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14:$A$17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C$14:$C$17</c:f>
              <c:numCache>
                <c:formatCode>General</c:formatCode>
                <c:ptCount val="4"/>
                <c:pt idx="0">
                  <c:v>7.2756967409170845E-3</c:v>
                </c:pt>
                <c:pt idx="1">
                  <c:v>2.6680645607300799E-2</c:v>
                </c:pt>
                <c:pt idx="2">
                  <c:v>7.5732980604918579E-2</c:v>
                </c:pt>
                <c:pt idx="3">
                  <c:v>9.3916708857061409E-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8B54-2749-95FC-99C85457F744}"/>
            </c:ext>
          </c:extLst>
        </c:ser>
        <c:ser>
          <c:idx val="2"/>
          <c:order val="2"/>
          <c:tx>
            <c:strRef>
              <c:f>Data!$D$13</c:f>
              <c:strCache>
                <c:ptCount val="1"/>
                <c:pt idx="0">
                  <c:v>Younger females</c:v>
                </c:pt>
              </c:strCache>
            </c:strRef>
          </c:tx>
          <c:spPr>
            <a:ln w="2222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triang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14:$A$17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D$14:$D$17</c:f>
              <c:numCache>
                <c:formatCode>General</c:formatCode>
                <c:ptCount val="4"/>
                <c:pt idx="0">
                  <c:v>9.1066779402483693E-3</c:v>
                </c:pt>
                <c:pt idx="1">
                  <c:v>4.8029028274261948E-2</c:v>
                </c:pt>
                <c:pt idx="2">
                  <c:v>8.6375347998346869E-2</c:v>
                </c:pt>
                <c:pt idx="3">
                  <c:v>9.4890238727072793E-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8B54-2749-95FC-99C85457F744}"/>
            </c:ext>
          </c:extLst>
        </c:ser>
        <c:ser>
          <c:idx val="3"/>
          <c:order val="3"/>
          <c:tx>
            <c:strRef>
              <c:f>Data!$E$13</c:f>
              <c:strCache>
                <c:ptCount val="1"/>
                <c:pt idx="0">
                  <c:v>Younger males</c:v>
                </c:pt>
              </c:strCache>
            </c:strRef>
          </c:tx>
          <c:spPr>
            <a:ln w="12700" cap="rnd">
              <a:solidFill>
                <a:schemeClr val="tx1"/>
              </a:solidFill>
              <a:prstDash val="lgDashDotDot"/>
              <a:round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14:$A$17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E$14:$E$17</c:f>
              <c:numCache>
                <c:formatCode>General</c:formatCode>
                <c:ptCount val="4"/>
                <c:pt idx="0">
                  <c:v>5.366461033797041E-3</c:v>
                </c:pt>
                <c:pt idx="1">
                  <c:v>4.496022450439336E-2</c:v>
                </c:pt>
                <c:pt idx="2">
                  <c:v>7.3968701111273974E-2</c:v>
                </c:pt>
                <c:pt idx="3">
                  <c:v>8.5634838933401514E-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8B54-2749-95FC-99C85457F74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2032112"/>
        <c:axId val="181721936"/>
      </c:scatterChart>
      <c:scatterChart>
        <c:scatterStyle val="lineMarker"/>
        <c:varyColors val="0"/>
        <c:ser>
          <c:idx val="4"/>
          <c:order val="4"/>
          <c:tx>
            <c:strRef>
              <c:f>Data!$F$13</c:f>
              <c:strCache>
                <c:ptCount val="1"/>
                <c:pt idx="0">
                  <c:v>Tmax/ Cmax (secondary axis)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x"/>
            <c:size val="6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dLbls>
            <c:dLbl>
              <c:idx val="0"/>
              <c:layout>
                <c:manualLayout>
                  <c:x val="-0.10642990936159889"/>
                  <c:y val="0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older fe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8B54-2749-95FC-99C85457F744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/>
                      <a:t>older 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8B54-2749-95FC-99C85457F744}"/>
                </c:ext>
              </c:extLst>
            </c:dLbl>
            <c:dLbl>
              <c:idx val="2"/>
              <c:layout>
                <c:manualLayout>
                  <c:x val="-0.15282243395511638"/>
                  <c:y val="-4.3925500243426695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younger fe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8B54-2749-95FC-99C85457F744}"/>
                </c:ext>
              </c:extLst>
            </c:dLbl>
            <c:dLbl>
              <c:idx val="3"/>
              <c:layout>
                <c:manualLayout>
                  <c:x val="9.5514021221947219E-3"/>
                  <c:y val="8.3667619511288878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younger 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8B54-2749-95FC-99C85457F74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Data!$G$14:$G$17</c:f>
              <c:numCache>
                <c:formatCode>0.00</c:formatCode>
                <c:ptCount val="4"/>
                <c:pt idx="0">
                  <c:v>9.9886363636363651</c:v>
                </c:pt>
                <c:pt idx="1">
                  <c:v>11.945652173913039</c:v>
                </c:pt>
                <c:pt idx="2">
                  <c:v>5.9880952380952355</c:v>
                </c:pt>
                <c:pt idx="3">
                  <c:v>8.435483870967742</c:v>
                </c:pt>
              </c:numCache>
            </c:numRef>
          </c:xVal>
          <c:yVal>
            <c:numRef>
              <c:f>Data!$I$14:$I$17</c:f>
              <c:numCache>
                <c:formatCode>General</c:formatCode>
                <c:ptCount val="4"/>
                <c:pt idx="0">
                  <c:v>0.37280578518138191</c:v>
                </c:pt>
                <c:pt idx="1">
                  <c:v>0.35530840805024688</c:v>
                </c:pt>
                <c:pt idx="2">
                  <c:v>0.25781713494281921</c:v>
                </c:pt>
                <c:pt idx="3">
                  <c:v>0.244538359273123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8B54-2749-95FC-99C85457F74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3810576"/>
        <c:axId val="207755872"/>
      </c:scatterChart>
      <c:valAx>
        <c:axId val="182032112"/>
        <c:scaling>
          <c:orientation val="minMax"/>
          <c:max val="2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Time (hours)</a:t>
                </a:r>
              </a:p>
            </c:rich>
          </c:tx>
          <c:layout>
            <c:manualLayout>
              <c:xMode val="edge"/>
              <c:yMode val="edge"/>
              <c:x val="0.46761979600830411"/>
              <c:y val="0.94242507153449318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1721936"/>
        <c:crosses val="autoZero"/>
        <c:crossBetween val="midCat"/>
        <c:majorUnit val="4"/>
      </c:valAx>
      <c:valAx>
        <c:axId val="1817219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>
                    <a:solidFill>
                      <a:schemeClr val="tx1"/>
                    </a:solidFill>
                  </a:rPr>
                  <a:t>Cumulative</a:t>
                </a:r>
                <a:r>
                  <a:rPr lang="en-GB" baseline="0">
                    <a:solidFill>
                      <a:schemeClr val="tx1"/>
                    </a:solidFill>
                  </a:rPr>
                  <a:t> c</a:t>
                </a:r>
                <a:r>
                  <a:rPr lang="en-GB">
                    <a:solidFill>
                      <a:schemeClr val="tx1"/>
                    </a:solidFill>
                  </a:rPr>
                  <a:t>oncentration </a:t>
                </a:r>
                <a:r>
                  <a:rPr lang="en-GB" sz="1100" b="0" i="0" u="none" strike="noStrike" baseline="0">
                    <a:effectLst/>
                  </a:rPr>
                  <a:t>(x 10^2) </a:t>
                </a:r>
                <a:endParaRPr lang="en-GB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1.5616992582602829E-2"/>
              <c:y val="0.3611130140562668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.0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2032112"/>
        <c:crosses val="autoZero"/>
        <c:crossBetween val="midCat"/>
      </c:valAx>
      <c:valAx>
        <c:axId val="207755872"/>
        <c:scaling>
          <c:orientation val="minMax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Maximum concentration </a:t>
                </a:r>
                <a:r>
                  <a:rPr lang="en-GB" sz="1100" b="0" i="0" u="none" strike="noStrike" baseline="0">
                    <a:effectLst/>
                  </a:rPr>
                  <a:t>(x 10^2) </a:t>
                </a:r>
                <a:endParaRPr lang="en-GB"/>
              </a:p>
            </c:rich>
          </c:tx>
          <c:layout>
            <c:manualLayout>
              <c:xMode val="edge"/>
              <c:yMode val="edge"/>
              <c:x val="0.96723353299592907"/>
              <c:y val="0.3558178395937793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.0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  <a:prstDash val="sysDot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810576"/>
        <c:crosses val="max"/>
        <c:crossBetween val="midCat"/>
      </c:valAx>
      <c:valAx>
        <c:axId val="193810576"/>
        <c:scaling>
          <c:orientation val="minMax"/>
          <c:max val="24"/>
          <c:min val="0"/>
        </c:scaling>
        <c:delete val="1"/>
        <c:axPos val="t"/>
        <c:numFmt formatCode="0.00" sourceLinked="1"/>
        <c:majorTickMark val="out"/>
        <c:minorTickMark val="none"/>
        <c:tickLblPos val="nextTo"/>
        <c:crossAx val="207755872"/>
        <c:crosses val="max"/>
        <c:crossBetween val="midCat"/>
        <c:majorUnit val="4"/>
      </c:valAx>
    </c:plotArea>
    <c:legend>
      <c:legendPos val="l"/>
      <c:layout>
        <c:manualLayout>
          <c:xMode val="edge"/>
          <c:yMode val="edge"/>
          <c:x val="0.6565552164515327"/>
          <c:y val="2.5270915093177401E-2"/>
          <c:w val="0.24774521371611433"/>
          <c:h val="0.1267740664637123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b="1"/>
              <a:t>Benzoic acid-4-sulfate</a:t>
            </a: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0409953867867502"/>
          <c:y val="5.1549654467208252E-2"/>
          <c:w val="0.8137110249163827"/>
          <c:h val="0.83488085096061249"/>
        </c:manualLayout>
      </c:layout>
      <c:scatterChart>
        <c:scatterStyle val="smoothMarker"/>
        <c:varyColors val="0"/>
        <c:ser>
          <c:idx val="1"/>
          <c:order val="0"/>
          <c:tx>
            <c:strRef>
              <c:f>Data!$B$5</c:f>
              <c:strCache>
                <c:ptCount val="1"/>
                <c:pt idx="0">
                  <c:v>Older females</c:v>
                </c:pt>
              </c:strCache>
            </c:strRef>
          </c:tx>
          <c:spPr>
            <a:ln w="2222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squar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B$75:$B$78</c:f>
              <c:numCache>
                <c:formatCode>0.000</c:formatCode>
                <c:ptCount val="4"/>
                <c:pt idx="0">
                  <c:v>0.29271940403827001</c:v>
                </c:pt>
                <c:pt idx="1">
                  <c:v>0.94014534388725335</c:v>
                </c:pt>
                <c:pt idx="2">
                  <c:v>1.4198950382455504</c:v>
                </c:pt>
                <c:pt idx="3">
                  <c:v>1.926074629712362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8BB5-FA4E-B263-2FB490449D91}"/>
            </c:ext>
          </c:extLst>
        </c:ser>
        <c:ser>
          <c:idx val="0"/>
          <c:order val="1"/>
          <c:tx>
            <c:strRef>
              <c:f>Data!$C$5</c:f>
              <c:strCache>
                <c:ptCount val="1"/>
                <c:pt idx="0">
                  <c:v>Older males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C$75:$C$78</c:f>
              <c:numCache>
                <c:formatCode>0.000</c:formatCode>
                <c:ptCount val="4"/>
                <c:pt idx="0">
                  <c:v>0.46103139955418054</c:v>
                </c:pt>
                <c:pt idx="1">
                  <c:v>1.2865210739154167</c:v>
                </c:pt>
                <c:pt idx="2">
                  <c:v>2.8543647851620304</c:v>
                </c:pt>
                <c:pt idx="3">
                  <c:v>3.496266319550215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8BB5-FA4E-B263-2FB490449D91}"/>
            </c:ext>
          </c:extLst>
        </c:ser>
        <c:ser>
          <c:idx val="2"/>
          <c:order val="2"/>
          <c:tx>
            <c:strRef>
              <c:f>Data!$D$5</c:f>
              <c:strCache>
                <c:ptCount val="1"/>
                <c:pt idx="0">
                  <c:v>Younger females</c:v>
                </c:pt>
              </c:strCache>
            </c:strRef>
          </c:tx>
          <c:spPr>
            <a:ln w="2222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triang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D$75:$D$78</c:f>
              <c:numCache>
                <c:formatCode>0.000</c:formatCode>
                <c:ptCount val="4"/>
                <c:pt idx="0">
                  <c:v>0.29054610252886642</c:v>
                </c:pt>
                <c:pt idx="1">
                  <c:v>0.98882763519352312</c:v>
                </c:pt>
                <c:pt idx="2">
                  <c:v>1.5371697456009477</c:v>
                </c:pt>
                <c:pt idx="3">
                  <c:v>1.83716668297575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8BB5-FA4E-B263-2FB490449D91}"/>
            </c:ext>
          </c:extLst>
        </c:ser>
        <c:ser>
          <c:idx val="3"/>
          <c:order val="3"/>
          <c:tx>
            <c:strRef>
              <c:f>Data!$E$5</c:f>
              <c:strCache>
                <c:ptCount val="1"/>
                <c:pt idx="0">
                  <c:v>Younger males</c:v>
                </c:pt>
              </c:strCache>
            </c:strRef>
          </c:tx>
          <c:spPr>
            <a:ln w="12700" cap="rnd">
              <a:solidFill>
                <a:schemeClr val="tx1"/>
              </a:solidFill>
              <a:prstDash val="lgDashDotDot"/>
              <a:round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E$75:$E$78</c:f>
              <c:numCache>
                <c:formatCode>0.000</c:formatCode>
                <c:ptCount val="4"/>
                <c:pt idx="0">
                  <c:v>0.39533961997095757</c:v>
                </c:pt>
                <c:pt idx="1">
                  <c:v>0.95129763482842389</c:v>
                </c:pt>
                <c:pt idx="2">
                  <c:v>1.4178149551037298</c:v>
                </c:pt>
                <c:pt idx="3">
                  <c:v>1.79989463487058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8BB5-FA4E-B263-2FB490449D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2032112"/>
        <c:axId val="181721936"/>
      </c:scatterChart>
      <c:scatterChart>
        <c:scatterStyle val="lineMarker"/>
        <c:varyColors val="0"/>
        <c:ser>
          <c:idx val="4"/>
          <c:order val="4"/>
          <c:tx>
            <c:strRef>
              <c:f>Data!$F$5</c:f>
              <c:strCache>
                <c:ptCount val="1"/>
                <c:pt idx="0">
                  <c:v>Tmax/ Cmax (secondary axis)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x"/>
            <c:size val="6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dLbls>
            <c:dLbl>
              <c:idx val="0"/>
              <c:layout>
                <c:manualLayout>
                  <c:x val="4.0934580523692881E-3"/>
                  <c:y val="-4.1833809755644439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older fe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4-8BB5-FA4E-B263-2FB490449D91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/>
                      <a:t>older 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5-8BB5-FA4E-B263-2FB490449D91}"/>
                </c:ext>
              </c:extLst>
            </c:dLbl>
            <c:dLbl>
              <c:idx val="2"/>
              <c:layout>
                <c:manualLayout>
                  <c:x val="-0.11052336741396813"/>
                  <c:y val="-3.1375357316733327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younger fe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6-8BB5-FA4E-B263-2FB490449D91}"/>
                </c:ext>
              </c:extLst>
            </c:dLbl>
            <c:dLbl>
              <c:idx val="3"/>
              <c:layout>
                <c:manualLayout>
                  <c:x val="8.1869161047383263E-3"/>
                  <c:y val="-2.0916904877822219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younger 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7-8BB5-FA4E-B263-2FB490449D91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Data!$G$75:$G$78</c:f>
              <c:numCache>
                <c:formatCode>0.00</c:formatCode>
                <c:ptCount val="4"/>
                <c:pt idx="0">
                  <c:v>12.15909090909091</c:v>
                </c:pt>
                <c:pt idx="1">
                  <c:v>10.065217391304348</c:v>
                </c:pt>
                <c:pt idx="2">
                  <c:v>9.8809523809523832</c:v>
                </c:pt>
                <c:pt idx="3">
                  <c:v>8.5161290322580658</c:v>
                </c:pt>
              </c:numCache>
            </c:numRef>
          </c:xVal>
          <c:yVal>
            <c:numRef>
              <c:f>Data!$F$75:$F$78</c:f>
              <c:numCache>
                <c:formatCode>0.00</c:formatCode>
                <c:ptCount val="4"/>
                <c:pt idx="0">
                  <c:v>9.6863864585757309</c:v>
                </c:pt>
                <c:pt idx="1">
                  <c:v>17.282782507979348</c:v>
                </c:pt>
                <c:pt idx="2">
                  <c:v>8.1216769712727235</c:v>
                </c:pt>
                <c:pt idx="3">
                  <c:v>10.83822132695105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8BB5-FA4E-B263-2FB490449D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3810576"/>
        <c:axId val="207755872"/>
      </c:scatterChart>
      <c:valAx>
        <c:axId val="182032112"/>
        <c:scaling>
          <c:orientation val="minMax"/>
          <c:max val="2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Time (hours)</a:t>
                </a:r>
              </a:p>
            </c:rich>
          </c:tx>
          <c:layout>
            <c:manualLayout>
              <c:xMode val="edge"/>
              <c:yMode val="edge"/>
              <c:x val="0.46761979600830411"/>
              <c:y val="0.94242507153449318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1721936"/>
        <c:crosses val="autoZero"/>
        <c:crossBetween val="midCat"/>
        <c:majorUnit val="4"/>
      </c:valAx>
      <c:valAx>
        <c:axId val="1817219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>
                    <a:solidFill>
                      <a:schemeClr val="tx1"/>
                    </a:solidFill>
                  </a:rPr>
                  <a:t>Cumulative</a:t>
                </a:r>
                <a:r>
                  <a:rPr lang="en-GB" baseline="0">
                    <a:solidFill>
                      <a:schemeClr val="tx1"/>
                    </a:solidFill>
                  </a:rPr>
                  <a:t> c</a:t>
                </a:r>
                <a:r>
                  <a:rPr lang="en-GB">
                    <a:solidFill>
                      <a:schemeClr val="tx1"/>
                    </a:solidFill>
                  </a:rPr>
                  <a:t>oncentration</a:t>
                </a:r>
              </a:p>
            </c:rich>
          </c:tx>
          <c:layout>
            <c:manualLayout>
              <c:xMode val="edge"/>
              <c:yMode val="edge"/>
              <c:x val="1.5616992582602829E-2"/>
              <c:y val="0.3611130140562668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2032112"/>
        <c:crosses val="autoZero"/>
        <c:crossBetween val="midCat"/>
      </c:valAx>
      <c:valAx>
        <c:axId val="207755872"/>
        <c:scaling>
          <c:orientation val="minMax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Maximum concentration</a:t>
                </a:r>
              </a:p>
            </c:rich>
          </c:tx>
          <c:layout>
            <c:manualLayout>
              <c:xMode val="edge"/>
              <c:yMode val="edge"/>
              <c:x val="0.96723353299592907"/>
              <c:y val="0.3558178395937793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  <a:prstDash val="sysDot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810576"/>
        <c:crosses val="max"/>
        <c:crossBetween val="midCat"/>
      </c:valAx>
      <c:valAx>
        <c:axId val="193810576"/>
        <c:scaling>
          <c:orientation val="minMax"/>
          <c:max val="24"/>
          <c:min val="0"/>
        </c:scaling>
        <c:delete val="1"/>
        <c:axPos val="t"/>
        <c:numFmt formatCode="0.00" sourceLinked="1"/>
        <c:majorTickMark val="out"/>
        <c:minorTickMark val="none"/>
        <c:tickLblPos val="nextTo"/>
        <c:crossAx val="207755872"/>
        <c:crosses val="max"/>
        <c:crossBetween val="midCat"/>
        <c:majorUnit val="4"/>
      </c:valAx>
    </c:plotArea>
    <c:legend>
      <c:legendPos val="l"/>
      <c:layout>
        <c:manualLayout>
          <c:xMode val="edge"/>
          <c:yMode val="edge"/>
          <c:x val="0.6565552164515327"/>
          <c:y val="2.5270915093177401E-2"/>
          <c:w val="0.24774521371611433"/>
          <c:h val="0.1267740664637123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b="1" dirty="0" err="1"/>
              <a:t>Hippuric</a:t>
            </a:r>
            <a:r>
              <a:rPr lang="en-GB" b="1" dirty="0"/>
              <a:t> acid</a:t>
            </a: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0409953867867502"/>
          <c:y val="5.1549654467208252E-2"/>
          <c:w val="0.8137110249163827"/>
          <c:h val="0.83488085096061249"/>
        </c:manualLayout>
      </c:layout>
      <c:scatterChart>
        <c:scatterStyle val="smoothMarker"/>
        <c:varyColors val="0"/>
        <c:ser>
          <c:idx val="1"/>
          <c:order val="0"/>
          <c:tx>
            <c:strRef>
              <c:f>Data!$B$5</c:f>
              <c:strCache>
                <c:ptCount val="1"/>
                <c:pt idx="0">
                  <c:v>Older females</c:v>
                </c:pt>
              </c:strCache>
            </c:strRef>
          </c:tx>
          <c:spPr>
            <a:ln w="2222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squar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B$81:$B$84</c:f>
              <c:numCache>
                <c:formatCode>General</c:formatCode>
                <c:ptCount val="4"/>
                <c:pt idx="0">
                  <c:v>8.5031303267304423</c:v>
                </c:pt>
                <c:pt idx="1">
                  <c:v>26.290768913167284</c:v>
                </c:pt>
                <c:pt idx="2">
                  <c:v>44.977335654293192</c:v>
                </c:pt>
                <c:pt idx="3">
                  <c:v>58.1282534894989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2971-A94F-93A5-C47BE9B84EAB}"/>
            </c:ext>
          </c:extLst>
        </c:ser>
        <c:ser>
          <c:idx val="0"/>
          <c:order val="1"/>
          <c:tx>
            <c:strRef>
              <c:f>Data!$C$5</c:f>
              <c:strCache>
                <c:ptCount val="1"/>
                <c:pt idx="0">
                  <c:v>Older males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C$81:$C$84</c:f>
              <c:numCache>
                <c:formatCode>General</c:formatCode>
                <c:ptCount val="4"/>
                <c:pt idx="0">
                  <c:v>10.741501622746469</c:v>
                </c:pt>
                <c:pt idx="1">
                  <c:v>28.544921680712452</c:v>
                </c:pt>
                <c:pt idx="2">
                  <c:v>58.05929178063068</c:v>
                </c:pt>
                <c:pt idx="3">
                  <c:v>77.75457151884320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2971-A94F-93A5-C47BE9B84EAB}"/>
            </c:ext>
          </c:extLst>
        </c:ser>
        <c:ser>
          <c:idx val="2"/>
          <c:order val="2"/>
          <c:tx>
            <c:strRef>
              <c:f>Data!$D$5</c:f>
              <c:strCache>
                <c:ptCount val="1"/>
                <c:pt idx="0">
                  <c:v>Younger females</c:v>
                </c:pt>
              </c:strCache>
            </c:strRef>
          </c:tx>
          <c:spPr>
            <a:ln w="2222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triang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D$81:$D$84</c:f>
              <c:numCache>
                <c:formatCode>General</c:formatCode>
                <c:ptCount val="4"/>
                <c:pt idx="0">
                  <c:v>9.0475727808001647</c:v>
                </c:pt>
                <c:pt idx="1">
                  <c:v>26.039633191628329</c:v>
                </c:pt>
                <c:pt idx="2">
                  <c:v>48.043087084448324</c:v>
                </c:pt>
                <c:pt idx="3">
                  <c:v>58.71446897761037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2971-A94F-93A5-C47BE9B84EAB}"/>
            </c:ext>
          </c:extLst>
        </c:ser>
        <c:ser>
          <c:idx val="3"/>
          <c:order val="3"/>
          <c:tx>
            <c:strRef>
              <c:f>Data!$E$5</c:f>
              <c:strCache>
                <c:ptCount val="1"/>
                <c:pt idx="0">
                  <c:v>Younger males</c:v>
                </c:pt>
              </c:strCache>
            </c:strRef>
          </c:tx>
          <c:spPr>
            <a:ln w="12700" cap="rnd">
              <a:solidFill>
                <a:schemeClr val="tx1"/>
              </a:solidFill>
              <a:prstDash val="lgDashDotDot"/>
              <a:round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E$81:$E$84</c:f>
              <c:numCache>
                <c:formatCode>General</c:formatCode>
                <c:ptCount val="4"/>
                <c:pt idx="0">
                  <c:v>8.3199522404264581</c:v>
                </c:pt>
                <c:pt idx="1">
                  <c:v>21.566080492225559</c:v>
                </c:pt>
                <c:pt idx="2">
                  <c:v>34.121290367332357</c:v>
                </c:pt>
                <c:pt idx="3">
                  <c:v>45.559629036078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2971-A94F-93A5-C47BE9B84EA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2032112"/>
        <c:axId val="181721936"/>
      </c:scatterChart>
      <c:scatterChart>
        <c:scatterStyle val="lineMarker"/>
        <c:varyColors val="0"/>
        <c:ser>
          <c:idx val="4"/>
          <c:order val="4"/>
          <c:tx>
            <c:strRef>
              <c:f>Data!$F$5</c:f>
              <c:strCache>
                <c:ptCount val="1"/>
                <c:pt idx="0">
                  <c:v>Tmax/ Cmax (secondary axis)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x"/>
            <c:size val="6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dLbls>
            <c:dLbl>
              <c:idx val="0"/>
              <c:layout>
                <c:manualLayout>
                  <c:x val="6.8224300872819802E-3"/>
                  <c:y val="-6.2750714633466268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older fe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4-2971-A94F-93A5-C47BE9B84EAB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/>
                      <a:t>older 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5-2971-A94F-93A5-C47BE9B84EAB}"/>
                </c:ext>
              </c:extLst>
            </c:dLbl>
            <c:dLbl>
              <c:idx val="2"/>
              <c:layout>
                <c:manualLayout>
                  <c:x val="-5.4579440698255344E-3"/>
                  <c:y val="-3.9742119267862287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younger fe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6-2971-A94F-93A5-C47BE9B84EAB}"/>
                </c:ext>
              </c:extLst>
            </c:dLbl>
            <c:dLbl>
              <c:idx val="3"/>
              <c:layout>
                <c:manualLayout>
                  <c:x val="0"/>
                  <c:y val="4.8108881218991102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younger 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7-2971-A94F-93A5-C47BE9B84EA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Data!$G$81:$G$84</c:f>
              <c:numCache>
                <c:formatCode>0.00</c:formatCode>
                <c:ptCount val="4"/>
                <c:pt idx="0">
                  <c:v>11.772727272727275</c:v>
                </c:pt>
                <c:pt idx="1">
                  <c:v>12.67391304347826</c:v>
                </c:pt>
                <c:pt idx="2">
                  <c:v>7.5952380952380967</c:v>
                </c:pt>
                <c:pt idx="3">
                  <c:v>8.5161290322580641</c:v>
                </c:pt>
              </c:numCache>
            </c:numRef>
          </c:xVal>
          <c:yVal>
            <c:numRef>
              <c:f>Data!$F$81:$F$84</c:f>
              <c:numCache>
                <c:formatCode>0.00</c:formatCode>
                <c:ptCount val="4"/>
                <c:pt idx="0">
                  <c:v>283.09837754567462</c:v>
                </c:pt>
                <c:pt idx="1">
                  <c:v>381.65842201835227</c:v>
                </c:pt>
                <c:pt idx="2">
                  <c:v>256.28785677517158</c:v>
                </c:pt>
                <c:pt idx="3">
                  <c:v>242.9024562835693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2971-A94F-93A5-C47BE9B84EA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3810576"/>
        <c:axId val="207755872"/>
      </c:scatterChart>
      <c:valAx>
        <c:axId val="182032112"/>
        <c:scaling>
          <c:orientation val="minMax"/>
          <c:max val="2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Time (hours)</a:t>
                </a:r>
              </a:p>
            </c:rich>
          </c:tx>
          <c:layout>
            <c:manualLayout>
              <c:xMode val="edge"/>
              <c:yMode val="edge"/>
              <c:x val="0.46761979600830411"/>
              <c:y val="0.94242507153449318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1721936"/>
        <c:crosses val="autoZero"/>
        <c:crossBetween val="midCat"/>
        <c:majorUnit val="4"/>
      </c:valAx>
      <c:valAx>
        <c:axId val="1817219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>
                    <a:solidFill>
                      <a:schemeClr val="tx1"/>
                    </a:solidFill>
                  </a:rPr>
                  <a:t>Cumulative</a:t>
                </a:r>
                <a:r>
                  <a:rPr lang="en-GB" baseline="0">
                    <a:solidFill>
                      <a:schemeClr val="tx1"/>
                    </a:solidFill>
                  </a:rPr>
                  <a:t> c</a:t>
                </a:r>
                <a:r>
                  <a:rPr lang="en-GB">
                    <a:solidFill>
                      <a:schemeClr val="tx1"/>
                    </a:solidFill>
                  </a:rPr>
                  <a:t>oncentration</a:t>
                </a:r>
              </a:p>
            </c:rich>
          </c:tx>
          <c:layout>
            <c:manualLayout>
              <c:xMode val="edge"/>
              <c:yMode val="edge"/>
              <c:x val="1.5616992582602829E-2"/>
              <c:y val="0.3611130140562668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2032112"/>
        <c:crosses val="autoZero"/>
        <c:crossBetween val="midCat"/>
      </c:valAx>
      <c:valAx>
        <c:axId val="207755872"/>
        <c:scaling>
          <c:orientation val="minMax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Maximum concentration</a:t>
                </a:r>
              </a:p>
            </c:rich>
          </c:tx>
          <c:layout>
            <c:manualLayout>
              <c:xMode val="edge"/>
              <c:yMode val="edge"/>
              <c:x val="0.96723353299592907"/>
              <c:y val="0.3558178395937793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  <a:prstDash val="sysDot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810576"/>
        <c:crosses val="max"/>
        <c:crossBetween val="midCat"/>
      </c:valAx>
      <c:valAx>
        <c:axId val="193810576"/>
        <c:scaling>
          <c:orientation val="minMax"/>
          <c:max val="24"/>
          <c:min val="0"/>
        </c:scaling>
        <c:delete val="1"/>
        <c:axPos val="t"/>
        <c:numFmt formatCode="0.00" sourceLinked="1"/>
        <c:majorTickMark val="out"/>
        <c:minorTickMark val="none"/>
        <c:tickLblPos val="nextTo"/>
        <c:crossAx val="207755872"/>
        <c:crosses val="max"/>
        <c:crossBetween val="midCat"/>
        <c:majorUnit val="4"/>
      </c:valAx>
    </c:plotArea>
    <c:legend>
      <c:legendPos val="l"/>
      <c:layout>
        <c:manualLayout>
          <c:xMode val="edge"/>
          <c:yMode val="edge"/>
          <c:x val="0.6565552164515327"/>
          <c:y val="2.5270915093177401E-2"/>
          <c:w val="0.24774521371611433"/>
          <c:h val="0.1267740664637123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b="1" dirty="0"/>
              <a:t>3-hydroxyhippuric acid</a:t>
            </a: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0409953867867502"/>
          <c:y val="5.1549654467208252E-2"/>
          <c:w val="0.8137110249163827"/>
          <c:h val="0.83488085096061249"/>
        </c:manualLayout>
      </c:layout>
      <c:scatterChart>
        <c:scatterStyle val="smoothMarker"/>
        <c:varyColors val="0"/>
        <c:ser>
          <c:idx val="1"/>
          <c:order val="0"/>
          <c:tx>
            <c:strRef>
              <c:f>Data!$B$5</c:f>
              <c:strCache>
                <c:ptCount val="1"/>
                <c:pt idx="0">
                  <c:v>Older females</c:v>
                </c:pt>
              </c:strCache>
            </c:strRef>
          </c:tx>
          <c:spPr>
            <a:ln w="2222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squar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B$87:$B$90</c:f>
              <c:numCache>
                <c:formatCode>General</c:formatCode>
                <c:ptCount val="4"/>
                <c:pt idx="0">
                  <c:v>9.4542637462011733E-2</c:v>
                </c:pt>
                <c:pt idx="1">
                  <c:v>0.2923352395206415</c:v>
                </c:pt>
                <c:pt idx="2">
                  <c:v>0.73921575440574494</c:v>
                </c:pt>
                <c:pt idx="3">
                  <c:v>1.764732683266521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8726-6A40-BA07-3779FF9D19EC}"/>
            </c:ext>
          </c:extLst>
        </c:ser>
        <c:ser>
          <c:idx val="0"/>
          <c:order val="1"/>
          <c:tx>
            <c:strRef>
              <c:f>Data!$C$5</c:f>
              <c:strCache>
                <c:ptCount val="1"/>
                <c:pt idx="0">
                  <c:v>Older males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C$87:$C$90</c:f>
              <c:numCache>
                <c:formatCode>General</c:formatCode>
                <c:ptCount val="4"/>
                <c:pt idx="0">
                  <c:v>0.20401950131942601</c:v>
                </c:pt>
                <c:pt idx="1">
                  <c:v>0.42317002056088332</c:v>
                </c:pt>
                <c:pt idx="2">
                  <c:v>1.142734104200577</c:v>
                </c:pt>
                <c:pt idx="3">
                  <c:v>2.452517997186105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8726-6A40-BA07-3779FF9D19EC}"/>
            </c:ext>
          </c:extLst>
        </c:ser>
        <c:ser>
          <c:idx val="2"/>
          <c:order val="2"/>
          <c:tx>
            <c:strRef>
              <c:f>Data!$D$5</c:f>
              <c:strCache>
                <c:ptCount val="1"/>
                <c:pt idx="0">
                  <c:v>Younger females</c:v>
                </c:pt>
              </c:strCache>
            </c:strRef>
          </c:tx>
          <c:spPr>
            <a:ln w="2222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triang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D$87:$D$90</c:f>
              <c:numCache>
                <c:formatCode>General</c:formatCode>
                <c:ptCount val="4"/>
                <c:pt idx="0">
                  <c:v>0.17829111056038865</c:v>
                </c:pt>
                <c:pt idx="1">
                  <c:v>0.39000564468343035</c:v>
                </c:pt>
                <c:pt idx="2">
                  <c:v>0.87921092641062759</c:v>
                </c:pt>
                <c:pt idx="3">
                  <c:v>1.466666798039179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8726-6A40-BA07-3779FF9D19EC}"/>
            </c:ext>
          </c:extLst>
        </c:ser>
        <c:ser>
          <c:idx val="3"/>
          <c:order val="3"/>
          <c:tx>
            <c:strRef>
              <c:f>Data!$E$5</c:f>
              <c:strCache>
                <c:ptCount val="1"/>
                <c:pt idx="0">
                  <c:v>Younger males</c:v>
                </c:pt>
              </c:strCache>
            </c:strRef>
          </c:tx>
          <c:spPr>
            <a:ln w="12700" cap="rnd">
              <a:solidFill>
                <a:schemeClr val="tx1"/>
              </a:solidFill>
              <a:prstDash val="lgDashDotDot"/>
              <a:round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E$87:$E$90</c:f>
              <c:numCache>
                <c:formatCode>General</c:formatCode>
                <c:ptCount val="4"/>
                <c:pt idx="0">
                  <c:v>0.21789108619334646</c:v>
                </c:pt>
                <c:pt idx="1">
                  <c:v>0.55455288394745172</c:v>
                </c:pt>
                <c:pt idx="2">
                  <c:v>0.95745902984793929</c:v>
                </c:pt>
                <c:pt idx="3">
                  <c:v>1.645117721254188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8726-6A40-BA07-3779FF9D19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2032112"/>
        <c:axId val="181721936"/>
      </c:scatterChart>
      <c:scatterChart>
        <c:scatterStyle val="lineMarker"/>
        <c:varyColors val="0"/>
        <c:ser>
          <c:idx val="4"/>
          <c:order val="4"/>
          <c:tx>
            <c:strRef>
              <c:f>Data!$F$5</c:f>
              <c:strCache>
                <c:ptCount val="1"/>
                <c:pt idx="0">
                  <c:v>Tmax/ Cmax (secondary axis)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x"/>
            <c:size val="6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dLbls>
            <c:dLbl>
              <c:idx val="0"/>
              <c:layout>
                <c:manualLayout>
                  <c:x val="6.8224300872819802E-3"/>
                  <c:y val="-4.1833809755644439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older fe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4-8726-6A40-BA07-3779FF9D19EC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/>
                      <a:t>older 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5-8726-6A40-BA07-3779FF9D19EC}"/>
                </c:ext>
              </c:extLst>
            </c:dLbl>
            <c:dLbl>
              <c:idx val="2"/>
              <c:layout>
                <c:manualLayout>
                  <c:x val="-1.3644860174564961E-3"/>
                  <c:y val="3.5558738292297692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younger fe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6-8726-6A40-BA07-3779FF9D19EC}"/>
                </c:ext>
              </c:extLst>
            </c:dLbl>
            <c:dLbl>
              <c:idx val="3"/>
              <c:layout>
                <c:manualLayout>
                  <c:x val="1.77383182269331E-2"/>
                  <c:y val="-2.7191976341168805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younger 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7-8726-6A40-BA07-3779FF9D19EC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Data!$G$87:$G$90</c:f>
              <c:numCache>
                <c:formatCode>0.00</c:formatCode>
                <c:ptCount val="4"/>
                <c:pt idx="0">
                  <c:v>19.95454545454546</c:v>
                </c:pt>
                <c:pt idx="1">
                  <c:v>18.934782608695652</c:v>
                </c:pt>
                <c:pt idx="2">
                  <c:v>17.392857142857146</c:v>
                </c:pt>
                <c:pt idx="3">
                  <c:v>16.258064516129032</c:v>
                </c:pt>
              </c:numCache>
            </c:numRef>
          </c:xVal>
          <c:yVal>
            <c:numRef>
              <c:f>Data!$F$87:$F$90</c:f>
              <c:numCache>
                <c:formatCode>0.00</c:formatCode>
                <c:ptCount val="4"/>
                <c:pt idx="0">
                  <c:v>17.478782912546951</c:v>
                </c:pt>
                <c:pt idx="1">
                  <c:v>22.019727872765579</c:v>
                </c:pt>
                <c:pt idx="2">
                  <c:v>10.463513982005228</c:v>
                </c:pt>
                <c:pt idx="3">
                  <c:v>12.5522604911558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8726-6A40-BA07-3779FF9D19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3810576"/>
        <c:axId val="207755872"/>
      </c:scatterChart>
      <c:valAx>
        <c:axId val="182032112"/>
        <c:scaling>
          <c:orientation val="minMax"/>
          <c:max val="2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Time (hours)</a:t>
                </a:r>
              </a:p>
            </c:rich>
          </c:tx>
          <c:layout>
            <c:manualLayout>
              <c:xMode val="edge"/>
              <c:yMode val="edge"/>
              <c:x val="0.46761979600830411"/>
              <c:y val="0.94242507153449318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1721936"/>
        <c:crosses val="autoZero"/>
        <c:crossBetween val="midCat"/>
        <c:majorUnit val="4"/>
      </c:valAx>
      <c:valAx>
        <c:axId val="1817219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>
                    <a:solidFill>
                      <a:schemeClr val="tx1"/>
                    </a:solidFill>
                  </a:rPr>
                  <a:t>Cumulative</a:t>
                </a:r>
                <a:r>
                  <a:rPr lang="en-GB" baseline="0">
                    <a:solidFill>
                      <a:schemeClr val="tx1"/>
                    </a:solidFill>
                  </a:rPr>
                  <a:t> c</a:t>
                </a:r>
                <a:r>
                  <a:rPr lang="en-GB">
                    <a:solidFill>
                      <a:schemeClr val="tx1"/>
                    </a:solidFill>
                  </a:rPr>
                  <a:t>oncentration</a:t>
                </a:r>
              </a:p>
            </c:rich>
          </c:tx>
          <c:layout>
            <c:manualLayout>
              <c:xMode val="edge"/>
              <c:yMode val="edge"/>
              <c:x val="1.5616992582602829E-2"/>
              <c:y val="0.3611130140562668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2032112"/>
        <c:crosses val="autoZero"/>
        <c:crossBetween val="midCat"/>
      </c:valAx>
      <c:valAx>
        <c:axId val="207755872"/>
        <c:scaling>
          <c:orientation val="minMax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Maximum concentration</a:t>
                </a:r>
              </a:p>
            </c:rich>
          </c:tx>
          <c:layout>
            <c:manualLayout>
              <c:xMode val="edge"/>
              <c:yMode val="edge"/>
              <c:x val="0.96723353299592907"/>
              <c:y val="0.3558178395937793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  <a:prstDash val="sysDot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810576"/>
        <c:crosses val="max"/>
        <c:crossBetween val="midCat"/>
      </c:valAx>
      <c:valAx>
        <c:axId val="193810576"/>
        <c:scaling>
          <c:orientation val="minMax"/>
          <c:max val="24"/>
          <c:min val="0"/>
        </c:scaling>
        <c:delete val="1"/>
        <c:axPos val="t"/>
        <c:numFmt formatCode="0.00" sourceLinked="1"/>
        <c:majorTickMark val="out"/>
        <c:minorTickMark val="none"/>
        <c:tickLblPos val="nextTo"/>
        <c:crossAx val="207755872"/>
        <c:crosses val="max"/>
        <c:crossBetween val="midCat"/>
        <c:majorUnit val="4"/>
      </c:valAx>
    </c:plotArea>
    <c:legend>
      <c:legendPos val="l"/>
      <c:layout>
        <c:manualLayout>
          <c:xMode val="edge"/>
          <c:yMode val="edge"/>
          <c:x val="0.12031221159116902"/>
          <c:y val="5.0371200946564061E-2"/>
          <c:w val="0.24774521371611433"/>
          <c:h val="0.1267740664637123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b="1"/>
              <a:t>3-methylhippuric acid 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2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0409953867867502"/>
          <c:y val="5.1549654467208252E-2"/>
          <c:w val="0.8137110249163827"/>
          <c:h val="0.83488085096061249"/>
        </c:manualLayout>
      </c:layout>
      <c:scatterChart>
        <c:scatterStyle val="smoothMarker"/>
        <c:varyColors val="0"/>
        <c:ser>
          <c:idx val="1"/>
          <c:order val="0"/>
          <c:tx>
            <c:strRef>
              <c:f>Data!$B$5</c:f>
              <c:strCache>
                <c:ptCount val="1"/>
                <c:pt idx="0">
                  <c:v>Older females</c:v>
                </c:pt>
              </c:strCache>
            </c:strRef>
          </c:tx>
          <c:spPr>
            <a:ln w="2222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squar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B$6:$B$9</c:f>
              <c:numCache>
                <c:formatCode>General</c:formatCode>
                <c:ptCount val="4"/>
                <c:pt idx="0">
                  <c:v>2E-3</c:v>
                </c:pt>
                <c:pt idx="1">
                  <c:v>4.0000000000000001E-3</c:v>
                </c:pt>
                <c:pt idx="2">
                  <c:v>5.0000000000000001E-3</c:v>
                </c:pt>
                <c:pt idx="3">
                  <c:v>6.0000000000000001E-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B931-CA41-B220-3E3A4D94A7A4}"/>
            </c:ext>
          </c:extLst>
        </c:ser>
        <c:ser>
          <c:idx val="0"/>
          <c:order val="1"/>
          <c:tx>
            <c:strRef>
              <c:f>Data!$C$5</c:f>
              <c:strCache>
                <c:ptCount val="1"/>
                <c:pt idx="0">
                  <c:v>Older males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C$6:$C$9</c:f>
              <c:numCache>
                <c:formatCode>General</c:formatCode>
                <c:ptCount val="4"/>
                <c:pt idx="0">
                  <c:v>4.0000000000000001E-3</c:v>
                </c:pt>
                <c:pt idx="1">
                  <c:v>8.0000000000000002E-3</c:v>
                </c:pt>
                <c:pt idx="2">
                  <c:v>1.0999999999999999E-2</c:v>
                </c:pt>
                <c:pt idx="3">
                  <c:v>1.4E-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B931-CA41-B220-3E3A4D94A7A4}"/>
            </c:ext>
          </c:extLst>
        </c:ser>
        <c:ser>
          <c:idx val="2"/>
          <c:order val="2"/>
          <c:tx>
            <c:strRef>
              <c:f>Data!$D$5</c:f>
              <c:strCache>
                <c:ptCount val="1"/>
                <c:pt idx="0">
                  <c:v>Younger females</c:v>
                </c:pt>
              </c:strCache>
            </c:strRef>
          </c:tx>
          <c:spPr>
            <a:ln w="2222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triang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D$6:$D$9</c:f>
              <c:numCache>
                <c:formatCode>General</c:formatCode>
                <c:ptCount val="4"/>
                <c:pt idx="0">
                  <c:v>2E-3</c:v>
                </c:pt>
                <c:pt idx="1">
                  <c:v>3.0000000000000001E-3</c:v>
                </c:pt>
                <c:pt idx="2">
                  <c:v>5.0000000000000001E-3</c:v>
                </c:pt>
                <c:pt idx="3">
                  <c:v>6.0000000000000001E-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B931-CA41-B220-3E3A4D94A7A4}"/>
            </c:ext>
          </c:extLst>
        </c:ser>
        <c:ser>
          <c:idx val="3"/>
          <c:order val="3"/>
          <c:tx>
            <c:strRef>
              <c:f>Data!$E$5</c:f>
              <c:strCache>
                <c:ptCount val="1"/>
                <c:pt idx="0">
                  <c:v>Younger males</c:v>
                </c:pt>
              </c:strCache>
            </c:strRef>
          </c:tx>
          <c:spPr>
            <a:ln w="12700" cap="rnd">
              <a:solidFill>
                <a:schemeClr val="tx1"/>
              </a:solidFill>
              <a:prstDash val="lgDashDotDot"/>
              <a:round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E$6:$E$9</c:f>
              <c:numCache>
                <c:formatCode>General</c:formatCode>
                <c:ptCount val="4"/>
                <c:pt idx="0">
                  <c:v>1E-3</c:v>
                </c:pt>
                <c:pt idx="1">
                  <c:v>3.0000000000000001E-3</c:v>
                </c:pt>
                <c:pt idx="2">
                  <c:v>4.0000000000000001E-3</c:v>
                </c:pt>
                <c:pt idx="3">
                  <c:v>5.0000000000000001E-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B931-CA41-B220-3E3A4D94A7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2032112"/>
        <c:axId val="181721936"/>
      </c:scatterChart>
      <c:scatterChart>
        <c:scatterStyle val="lineMarker"/>
        <c:varyColors val="0"/>
        <c:ser>
          <c:idx val="4"/>
          <c:order val="4"/>
          <c:tx>
            <c:strRef>
              <c:f>Data!$F$5</c:f>
              <c:strCache>
                <c:ptCount val="1"/>
                <c:pt idx="0">
                  <c:v>Tmax/ Cmax (secondary axis)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x"/>
            <c:size val="6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dLbls>
            <c:dLbl>
              <c:idx val="0"/>
              <c:layout>
                <c:manualLayout>
                  <c:x val="-1.364486017456396E-2"/>
                  <c:y val="-3.5558738292297845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older fe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4-B931-CA41-B220-3E3A4D94A7A4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/>
                      <a:t>older 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5-B931-CA41-B220-3E3A4D94A7A4}"/>
                </c:ext>
              </c:extLst>
            </c:dLbl>
            <c:dLbl>
              <c:idx val="2"/>
              <c:layout>
                <c:manualLayout>
                  <c:x val="1.3644860174563461E-3"/>
                  <c:y val="-5.8567333657902211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younger fe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6-B931-CA41-B220-3E3A4D94A7A4}"/>
                </c:ext>
              </c:extLst>
            </c:dLbl>
            <c:dLbl>
              <c:idx val="3"/>
              <c:layout>
                <c:manualLayout>
                  <c:x val="1.77383182269331E-2"/>
                  <c:y val="-2.7191976341168805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younger 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7-B931-CA41-B220-3E3A4D94A7A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Data!$G$6:$G$9</c:f>
              <c:numCache>
                <c:formatCode>0.00</c:formatCode>
                <c:ptCount val="4"/>
                <c:pt idx="0">
                  <c:v>4.3636363636363678</c:v>
                </c:pt>
                <c:pt idx="1">
                  <c:v>4.1739130434782581</c:v>
                </c:pt>
                <c:pt idx="2">
                  <c:v>7.1071428571428559</c:v>
                </c:pt>
                <c:pt idx="3">
                  <c:v>9.2903225806451601</c:v>
                </c:pt>
              </c:numCache>
            </c:numRef>
          </c:xVal>
          <c:yVal>
            <c:numRef>
              <c:f>Data!$F$6:$F$9</c:f>
              <c:numCache>
                <c:formatCode>0.00</c:formatCode>
                <c:ptCount val="4"/>
                <c:pt idx="0">
                  <c:v>4.6722314394587176E-2</c:v>
                </c:pt>
                <c:pt idx="1">
                  <c:v>0.10714410165952437</c:v>
                </c:pt>
                <c:pt idx="2">
                  <c:v>4.2352794115209841E-2</c:v>
                </c:pt>
                <c:pt idx="3">
                  <c:v>4.1501387022435651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B931-CA41-B220-3E3A4D94A7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3810576"/>
        <c:axId val="207755872"/>
      </c:scatterChart>
      <c:valAx>
        <c:axId val="182032112"/>
        <c:scaling>
          <c:orientation val="minMax"/>
          <c:max val="2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Time (hours)</a:t>
                </a:r>
              </a:p>
            </c:rich>
          </c:tx>
          <c:layout>
            <c:manualLayout>
              <c:xMode val="edge"/>
              <c:yMode val="edge"/>
              <c:x val="0.46761979600830411"/>
              <c:y val="0.9424250715344931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1721936"/>
        <c:crosses val="autoZero"/>
        <c:crossBetween val="midCat"/>
        <c:majorUnit val="4"/>
      </c:valAx>
      <c:valAx>
        <c:axId val="1817219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>
                    <a:solidFill>
                      <a:schemeClr val="tx1"/>
                    </a:solidFill>
                  </a:rPr>
                  <a:t>Cumulative</a:t>
                </a:r>
                <a:r>
                  <a:rPr lang="en-GB" baseline="0">
                    <a:solidFill>
                      <a:schemeClr val="tx1"/>
                    </a:solidFill>
                  </a:rPr>
                  <a:t> c</a:t>
                </a:r>
                <a:r>
                  <a:rPr lang="en-GB">
                    <a:solidFill>
                      <a:schemeClr val="tx1"/>
                    </a:solidFill>
                  </a:rPr>
                  <a:t>oncentration</a:t>
                </a:r>
              </a:p>
            </c:rich>
          </c:tx>
          <c:layout>
            <c:manualLayout>
              <c:xMode val="edge"/>
              <c:yMode val="edge"/>
              <c:x val="1.5616992582602829E-2"/>
              <c:y val="0.3611130140562668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#,##0.00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2032112"/>
        <c:crosses val="autoZero"/>
        <c:crossBetween val="midCat"/>
      </c:valAx>
      <c:valAx>
        <c:axId val="207755872"/>
        <c:scaling>
          <c:orientation val="minMax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Maximum concentration</a:t>
                </a:r>
              </a:p>
            </c:rich>
          </c:tx>
          <c:layout>
            <c:manualLayout>
              <c:xMode val="edge"/>
              <c:yMode val="edge"/>
              <c:x val="0.96723353299592907"/>
              <c:y val="0.3558178395937793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#,##0.0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  <a:prstDash val="sysDot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810576"/>
        <c:crosses val="max"/>
        <c:crossBetween val="midCat"/>
      </c:valAx>
      <c:valAx>
        <c:axId val="193810576"/>
        <c:scaling>
          <c:orientation val="minMax"/>
          <c:max val="24"/>
          <c:min val="0"/>
        </c:scaling>
        <c:delete val="1"/>
        <c:axPos val="t"/>
        <c:numFmt formatCode="0.00" sourceLinked="1"/>
        <c:majorTickMark val="out"/>
        <c:minorTickMark val="none"/>
        <c:tickLblPos val="nextTo"/>
        <c:crossAx val="207755872"/>
        <c:crosses val="max"/>
        <c:crossBetween val="midCat"/>
        <c:majorUnit val="4"/>
      </c:valAx>
      <c:spPr>
        <a:noFill/>
        <a:ln>
          <a:noFill/>
        </a:ln>
        <a:effectLst/>
      </c:spPr>
    </c:plotArea>
    <c:legend>
      <c:legendPos val="l"/>
      <c:layout>
        <c:manualLayout>
          <c:xMode val="edge"/>
          <c:yMode val="edge"/>
          <c:x val="0.6565552164515327"/>
          <c:y val="2.5270915093177401E-2"/>
          <c:w val="0.24774521371611433"/>
          <c:h val="0.1267740664637123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>
          <a:solidFill>
            <a:schemeClr val="tx1"/>
          </a:solidFill>
        </a:defRPr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b="1" dirty="0" smtClean="0"/>
              <a:t>Naringenin-7-</a:t>
            </a:r>
            <a:r>
              <a:rPr lang="en-GB" b="1" i="1" dirty="0" smtClean="0"/>
              <a:t>O</a:t>
            </a:r>
            <a:r>
              <a:rPr lang="en-GB" b="1" dirty="0" smtClean="0"/>
              <a:t>-glucuronide </a:t>
            </a:r>
            <a:endParaRPr lang="en-GB" b="1" dirty="0"/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0409953867867502"/>
          <c:y val="5.1549654467208252E-2"/>
          <c:w val="0.8137110249163827"/>
          <c:h val="0.83488085096061249"/>
        </c:manualLayout>
      </c:layout>
      <c:scatterChart>
        <c:scatterStyle val="smoothMarker"/>
        <c:varyColors val="0"/>
        <c:ser>
          <c:idx val="1"/>
          <c:order val="0"/>
          <c:tx>
            <c:strRef>
              <c:f>Data!$B$5</c:f>
              <c:strCache>
                <c:ptCount val="1"/>
                <c:pt idx="0">
                  <c:v>Older females</c:v>
                </c:pt>
              </c:strCache>
            </c:strRef>
          </c:tx>
          <c:spPr>
            <a:ln w="2222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squar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B$21:$B$24</c:f>
              <c:numCache>
                <c:formatCode>General</c:formatCode>
                <c:ptCount val="4"/>
                <c:pt idx="0">
                  <c:v>5.5396388318509848E-2</c:v>
                </c:pt>
                <c:pt idx="1">
                  <c:v>1.2553607956993371</c:v>
                </c:pt>
                <c:pt idx="2">
                  <c:v>2.9227376049167608</c:v>
                </c:pt>
                <c:pt idx="3">
                  <c:v>3.419527152292000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96A3-CA45-8D25-CEE213D999D2}"/>
            </c:ext>
          </c:extLst>
        </c:ser>
        <c:ser>
          <c:idx val="0"/>
          <c:order val="1"/>
          <c:tx>
            <c:strRef>
              <c:f>Data!$C$5</c:f>
              <c:strCache>
                <c:ptCount val="1"/>
                <c:pt idx="0">
                  <c:v>Older males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C$21:$C$24</c:f>
              <c:numCache>
                <c:formatCode>General</c:formatCode>
                <c:ptCount val="4"/>
                <c:pt idx="0">
                  <c:v>0.12368600598594809</c:v>
                </c:pt>
                <c:pt idx="1">
                  <c:v>1.1695656814035584</c:v>
                </c:pt>
                <c:pt idx="2">
                  <c:v>3.6715034227137884</c:v>
                </c:pt>
                <c:pt idx="3">
                  <c:v>4.227957139838334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96A3-CA45-8D25-CEE213D999D2}"/>
            </c:ext>
          </c:extLst>
        </c:ser>
        <c:ser>
          <c:idx val="2"/>
          <c:order val="2"/>
          <c:tx>
            <c:strRef>
              <c:f>Data!$D$5</c:f>
              <c:strCache>
                <c:ptCount val="1"/>
                <c:pt idx="0">
                  <c:v>Younger females</c:v>
                </c:pt>
              </c:strCache>
            </c:strRef>
          </c:tx>
          <c:spPr>
            <a:ln w="2222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triang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D$21:$D$24</c:f>
              <c:numCache>
                <c:formatCode>General</c:formatCode>
                <c:ptCount val="4"/>
                <c:pt idx="0">
                  <c:v>0.14418095102623082</c:v>
                </c:pt>
                <c:pt idx="1">
                  <c:v>1.61746548366777</c:v>
                </c:pt>
                <c:pt idx="2">
                  <c:v>4.5773688515293411</c:v>
                </c:pt>
                <c:pt idx="3">
                  <c:v>4.949420094600917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96A3-CA45-8D25-CEE213D999D2}"/>
            </c:ext>
          </c:extLst>
        </c:ser>
        <c:ser>
          <c:idx val="3"/>
          <c:order val="3"/>
          <c:tx>
            <c:strRef>
              <c:f>Data!$E$5</c:f>
              <c:strCache>
                <c:ptCount val="1"/>
                <c:pt idx="0">
                  <c:v>Younger males</c:v>
                </c:pt>
              </c:strCache>
            </c:strRef>
          </c:tx>
          <c:spPr>
            <a:ln w="12700" cap="rnd">
              <a:solidFill>
                <a:schemeClr val="tx1"/>
              </a:solidFill>
              <a:prstDash val="lgDashDotDot"/>
              <a:round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E$21:$E$24</c:f>
              <c:numCache>
                <c:formatCode>General</c:formatCode>
                <c:ptCount val="4"/>
                <c:pt idx="0">
                  <c:v>0.11022161879128377</c:v>
                </c:pt>
                <c:pt idx="1">
                  <c:v>1.0423360041618943</c:v>
                </c:pt>
                <c:pt idx="2">
                  <c:v>2.096174667221983</c:v>
                </c:pt>
                <c:pt idx="3">
                  <c:v>2.374557054298454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96A3-CA45-8D25-CEE213D999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2032112"/>
        <c:axId val="181721936"/>
      </c:scatterChart>
      <c:scatterChart>
        <c:scatterStyle val="lineMarker"/>
        <c:varyColors val="0"/>
        <c:ser>
          <c:idx val="4"/>
          <c:order val="4"/>
          <c:tx>
            <c:strRef>
              <c:f>Data!$F$5</c:f>
              <c:strCache>
                <c:ptCount val="1"/>
                <c:pt idx="0">
                  <c:v>Tmax/ Cmax (secondary axis)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x"/>
            <c:size val="6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dLbls>
            <c:dLbl>
              <c:idx val="0"/>
              <c:layout>
                <c:manualLayout>
                  <c:x val="-0.10915888139651174"/>
                  <c:y val="-1.4641833414475591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older fe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4-96A3-CA45-8D25-CEE213D999D2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/>
                      <a:t>older 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5-96A3-CA45-8D25-CEE213D999D2}"/>
                </c:ext>
              </c:extLst>
            </c:dLbl>
            <c:dLbl>
              <c:idx val="2"/>
              <c:layout>
                <c:manualLayout>
                  <c:x val="-0.13099065767581403"/>
                  <c:y val="-4.1833809755644439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younger fe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6-96A3-CA45-8D25-CEE213D999D2}"/>
                </c:ext>
              </c:extLst>
            </c:dLbl>
            <c:dLbl>
              <c:idx val="3"/>
              <c:layout>
                <c:manualLayout>
                  <c:x val="1.3644860174563962E-3"/>
                  <c:y val="-4.1833809755644439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younger 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7-96A3-CA45-8D25-CEE213D999D2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xVal>
            <c:numRef>
              <c:f>Data!$G$21:$G$24</c:f>
              <c:numCache>
                <c:formatCode>0.00</c:formatCode>
                <c:ptCount val="4"/>
                <c:pt idx="0">
                  <c:v>11.136363636363644</c:v>
                </c:pt>
                <c:pt idx="1">
                  <c:v>13.326086956521737</c:v>
                </c:pt>
                <c:pt idx="2">
                  <c:v>8.4880952380952355</c:v>
                </c:pt>
                <c:pt idx="3">
                  <c:v>10.241935483870968</c:v>
                </c:pt>
              </c:numCache>
            </c:numRef>
          </c:xVal>
          <c:yVal>
            <c:numRef>
              <c:f>Data!$I$21:$I$24</c:f>
              <c:numCache>
                <c:formatCode>General</c:formatCode>
                <c:ptCount val="4"/>
                <c:pt idx="0">
                  <c:v>10.86993143279952</c:v>
                </c:pt>
                <c:pt idx="1">
                  <c:v>13.598840282825023</c:v>
                </c:pt>
                <c:pt idx="2">
                  <c:v>13.148806469204525</c:v>
                </c:pt>
                <c:pt idx="3">
                  <c:v>7.102831180447774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96A3-CA45-8D25-CEE213D999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3810576"/>
        <c:axId val="207755872"/>
      </c:scatterChart>
      <c:valAx>
        <c:axId val="182032112"/>
        <c:scaling>
          <c:orientation val="minMax"/>
          <c:max val="2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Time (hours)</a:t>
                </a:r>
              </a:p>
            </c:rich>
          </c:tx>
          <c:layout>
            <c:manualLayout>
              <c:xMode val="edge"/>
              <c:yMode val="edge"/>
              <c:x val="0.46761979600830411"/>
              <c:y val="0.94242507153449318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1721936"/>
        <c:crosses val="autoZero"/>
        <c:crossBetween val="midCat"/>
        <c:majorUnit val="4"/>
      </c:valAx>
      <c:valAx>
        <c:axId val="1817219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>
                    <a:solidFill>
                      <a:schemeClr val="tx1"/>
                    </a:solidFill>
                  </a:rPr>
                  <a:t>Cumulative</a:t>
                </a:r>
                <a:r>
                  <a:rPr lang="en-GB" baseline="0">
                    <a:solidFill>
                      <a:schemeClr val="tx1"/>
                    </a:solidFill>
                  </a:rPr>
                  <a:t> c</a:t>
                </a:r>
                <a:r>
                  <a:rPr lang="en-GB">
                    <a:solidFill>
                      <a:schemeClr val="tx1"/>
                    </a:solidFill>
                  </a:rPr>
                  <a:t>oncentration </a:t>
                </a:r>
                <a:r>
                  <a:rPr lang="en-GB" sz="1100" b="0" i="0" u="none" strike="noStrike" baseline="0">
                    <a:effectLst/>
                  </a:rPr>
                  <a:t>(x 10^2) </a:t>
                </a:r>
                <a:endParaRPr lang="en-GB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1.5616992582602829E-2"/>
              <c:y val="0.3611130140562668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2032112"/>
        <c:crosses val="autoZero"/>
        <c:crossBetween val="midCat"/>
      </c:valAx>
      <c:valAx>
        <c:axId val="207755872"/>
        <c:scaling>
          <c:orientation val="minMax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Maximum concentration </a:t>
                </a:r>
                <a:r>
                  <a:rPr lang="en-GB" sz="1100" b="0" i="0" u="none" strike="noStrike" baseline="0">
                    <a:effectLst/>
                  </a:rPr>
                  <a:t>(x 10^2) </a:t>
                </a:r>
                <a:endParaRPr lang="en-GB"/>
              </a:p>
            </c:rich>
          </c:tx>
          <c:layout>
            <c:manualLayout>
              <c:xMode val="edge"/>
              <c:yMode val="edge"/>
              <c:x val="0.96723353299592907"/>
              <c:y val="0.3558178395937793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  <a:prstDash val="sysDot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810576"/>
        <c:crosses val="max"/>
        <c:crossBetween val="midCat"/>
      </c:valAx>
      <c:valAx>
        <c:axId val="193810576"/>
        <c:scaling>
          <c:orientation val="minMax"/>
          <c:max val="24"/>
          <c:min val="0"/>
        </c:scaling>
        <c:delete val="1"/>
        <c:axPos val="t"/>
        <c:numFmt formatCode="0.00" sourceLinked="1"/>
        <c:majorTickMark val="out"/>
        <c:minorTickMark val="none"/>
        <c:tickLblPos val="nextTo"/>
        <c:crossAx val="207755872"/>
        <c:crosses val="max"/>
        <c:crossBetween val="midCat"/>
        <c:majorUnit val="4"/>
      </c:valAx>
    </c:plotArea>
    <c:legend>
      <c:legendPos val="l"/>
      <c:layout>
        <c:manualLayout>
          <c:xMode val="edge"/>
          <c:yMode val="edge"/>
          <c:x val="0.6565552164515327"/>
          <c:y val="2.5270915093177401E-2"/>
          <c:w val="0.24774521371611433"/>
          <c:h val="0.1267740664637123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b="1" dirty="0" smtClean="0"/>
              <a:t>(-)-</a:t>
            </a:r>
            <a:r>
              <a:rPr lang="en-GB" b="1" dirty="0" err="1" smtClean="0"/>
              <a:t>Epicatechin</a:t>
            </a:r>
            <a:endParaRPr lang="en-GB" b="1" dirty="0"/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0409953867867502"/>
          <c:y val="5.1549654467208252E-2"/>
          <c:w val="0.8137110249163827"/>
          <c:h val="0.83488085096061249"/>
        </c:manualLayout>
      </c:layout>
      <c:scatterChart>
        <c:scatterStyle val="smoothMarker"/>
        <c:varyColors val="0"/>
        <c:ser>
          <c:idx val="1"/>
          <c:order val="0"/>
          <c:tx>
            <c:strRef>
              <c:f>Data!$B$5</c:f>
              <c:strCache>
                <c:ptCount val="1"/>
                <c:pt idx="0">
                  <c:v>Older females</c:v>
                </c:pt>
              </c:strCache>
            </c:strRef>
          </c:tx>
          <c:spPr>
            <a:ln w="2222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squar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B$28:$B$31</c:f>
              <c:numCache>
                <c:formatCode>General</c:formatCode>
                <c:ptCount val="4"/>
                <c:pt idx="0">
                  <c:v>3.8974303794002602E-2</c:v>
                </c:pt>
                <c:pt idx="1">
                  <c:v>0.30269180986403882</c:v>
                </c:pt>
                <c:pt idx="2">
                  <c:v>0.66474610206753459</c:v>
                </c:pt>
                <c:pt idx="3">
                  <c:v>0.7308105249041738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AAB8-9A45-9944-C16AB4AB973A}"/>
            </c:ext>
          </c:extLst>
        </c:ser>
        <c:ser>
          <c:idx val="0"/>
          <c:order val="1"/>
          <c:tx>
            <c:strRef>
              <c:f>Data!$C$5</c:f>
              <c:strCache>
                <c:ptCount val="1"/>
                <c:pt idx="0">
                  <c:v>Older males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C$28:$C$31</c:f>
              <c:numCache>
                <c:formatCode>General</c:formatCode>
                <c:ptCount val="4"/>
                <c:pt idx="0">
                  <c:v>6.9191655823485076E-2</c:v>
                </c:pt>
                <c:pt idx="1">
                  <c:v>0.28246431817217582</c:v>
                </c:pt>
                <c:pt idx="2">
                  <c:v>0.80068653478634289</c:v>
                </c:pt>
                <c:pt idx="3">
                  <c:v>0.9512705094348100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AAB8-9A45-9944-C16AB4AB973A}"/>
            </c:ext>
          </c:extLst>
        </c:ser>
        <c:ser>
          <c:idx val="2"/>
          <c:order val="2"/>
          <c:tx>
            <c:strRef>
              <c:f>Data!$D$5</c:f>
              <c:strCache>
                <c:ptCount val="1"/>
                <c:pt idx="0">
                  <c:v>Younger females</c:v>
                </c:pt>
              </c:strCache>
            </c:strRef>
          </c:tx>
          <c:spPr>
            <a:ln w="2222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triang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D$28:$D$31</c:f>
              <c:numCache>
                <c:formatCode>General</c:formatCode>
                <c:ptCount val="4"/>
                <c:pt idx="0">
                  <c:v>5.0067928594483106E-2</c:v>
                </c:pt>
                <c:pt idx="1">
                  <c:v>0.34834741369505934</c:v>
                </c:pt>
                <c:pt idx="2">
                  <c:v>0.69543397729852885</c:v>
                </c:pt>
                <c:pt idx="3">
                  <c:v>0.7600550818762440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AAB8-9A45-9944-C16AB4AB973A}"/>
            </c:ext>
          </c:extLst>
        </c:ser>
        <c:ser>
          <c:idx val="3"/>
          <c:order val="3"/>
          <c:tx>
            <c:strRef>
              <c:f>Data!$E$5</c:f>
              <c:strCache>
                <c:ptCount val="1"/>
                <c:pt idx="0">
                  <c:v>Younger males</c:v>
                </c:pt>
              </c:strCache>
            </c:strRef>
          </c:tx>
          <c:spPr>
            <a:ln w="12700" cap="rnd">
              <a:solidFill>
                <a:schemeClr val="tx1"/>
              </a:solidFill>
              <a:prstDash val="lgDashDotDot"/>
              <a:round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E$28:$E$31</c:f>
              <c:numCache>
                <c:formatCode>General</c:formatCode>
                <c:ptCount val="4"/>
                <c:pt idx="0">
                  <c:v>6.1957687789470535E-2</c:v>
                </c:pt>
                <c:pt idx="1">
                  <c:v>0.33342531518995605</c:v>
                </c:pt>
                <c:pt idx="2">
                  <c:v>0.53613574998923252</c:v>
                </c:pt>
                <c:pt idx="3">
                  <c:v>0.5811780119555813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AAB8-9A45-9944-C16AB4AB97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2032112"/>
        <c:axId val="181721936"/>
      </c:scatterChart>
      <c:scatterChart>
        <c:scatterStyle val="lineMarker"/>
        <c:varyColors val="0"/>
        <c:ser>
          <c:idx val="4"/>
          <c:order val="4"/>
          <c:tx>
            <c:strRef>
              <c:f>Data!$F$5</c:f>
              <c:strCache>
                <c:ptCount val="1"/>
                <c:pt idx="0">
                  <c:v>Tmax/ Cmax (secondary axis)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x"/>
            <c:size val="6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dLbls>
            <c:dLbl>
              <c:idx val="0"/>
              <c:layout>
                <c:manualLayout>
                  <c:x val="-1.3644860174563962E-3"/>
                  <c:y val="-2.7191976341168884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older fe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4-AAB8-9A45-9944-C16AB4AB973A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/>
                      <a:t>older 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5-AAB8-9A45-9944-C16AB4AB973A}"/>
                </c:ext>
              </c:extLst>
            </c:dLbl>
            <c:dLbl>
              <c:idx val="2"/>
              <c:layout>
                <c:manualLayout>
                  <c:x val="-1.0915888139651169E-2"/>
                  <c:y val="2.7191976341168884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younger fe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6-AAB8-9A45-9944-C16AB4AB973A}"/>
                </c:ext>
              </c:extLst>
            </c:dLbl>
            <c:dLbl>
              <c:idx val="3"/>
              <c:layout>
                <c:manualLayout>
                  <c:x val="-0.13371962971072682"/>
                  <c:y val="-2.0916904877822218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younger 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7-AAB8-9A45-9944-C16AB4AB973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Data!$G$28:$G$31</c:f>
              <c:numCache>
                <c:formatCode>0.00</c:formatCode>
                <c:ptCount val="4"/>
                <c:pt idx="0">
                  <c:v>9.5568181818181905</c:v>
                </c:pt>
                <c:pt idx="1">
                  <c:v>9.6630434782608674</c:v>
                </c:pt>
                <c:pt idx="2">
                  <c:v>6.9047619047619033</c:v>
                </c:pt>
                <c:pt idx="3">
                  <c:v>5.7903225806451601</c:v>
                </c:pt>
              </c:numCache>
            </c:numRef>
          </c:xVal>
          <c:yVal>
            <c:numRef>
              <c:f>Data!$I$28:$I$31</c:f>
              <c:numCache>
                <c:formatCode>General</c:formatCode>
                <c:ptCount val="4"/>
                <c:pt idx="0">
                  <c:v>2.2621615981651404</c:v>
                </c:pt>
                <c:pt idx="1">
                  <c:v>4.0929349717613226</c:v>
                </c:pt>
                <c:pt idx="2">
                  <c:v>2.293296141277362</c:v>
                </c:pt>
                <c:pt idx="3">
                  <c:v>2.284028959054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AAB8-9A45-9944-C16AB4AB97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3810576"/>
        <c:axId val="207755872"/>
      </c:scatterChart>
      <c:valAx>
        <c:axId val="182032112"/>
        <c:scaling>
          <c:orientation val="minMax"/>
          <c:max val="2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Time (hours)</a:t>
                </a:r>
              </a:p>
            </c:rich>
          </c:tx>
          <c:layout>
            <c:manualLayout>
              <c:xMode val="edge"/>
              <c:yMode val="edge"/>
              <c:x val="0.46761979600830411"/>
              <c:y val="0.94242507153449318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1721936"/>
        <c:crosses val="autoZero"/>
        <c:crossBetween val="midCat"/>
        <c:majorUnit val="4"/>
      </c:valAx>
      <c:valAx>
        <c:axId val="1817219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>
                    <a:solidFill>
                      <a:schemeClr val="tx1"/>
                    </a:solidFill>
                  </a:rPr>
                  <a:t>Cumulative</a:t>
                </a:r>
                <a:r>
                  <a:rPr lang="en-GB" baseline="0">
                    <a:solidFill>
                      <a:schemeClr val="tx1"/>
                    </a:solidFill>
                  </a:rPr>
                  <a:t> c</a:t>
                </a:r>
                <a:r>
                  <a:rPr lang="en-GB">
                    <a:solidFill>
                      <a:schemeClr val="tx1"/>
                    </a:solidFill>
                  </a:rPr>
                  <a:t>oncentration </a:t>
                </a:r>
                <a:r>
                  <a:rPr lang="en-GB" sz="1100" b="0" i="0" u="none" strike="noStrike" baseline="0">
                    <a:effectLst/>
                  </a:rPr>
                  <a:t>(x 10^2) </a:t>
                </a:r>
                <a:endParaRPr lang="en-GB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1.5616992582602829E-2"/>
              <c:y val="0.3611130140562668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2032112"/>
        <c:crosses val="autoZero"/>
        <c:crossBetween val="midCat"/>
      </c:valAx>
      <c:valAx>
        <c:axId val="207755872"/>
        <c:scaling>
          <c:orientation val="minMax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Maximum concentration </a:t>
                </a:r>
                <a:r>
                  <a:rPr lang="en-GB" sz="1100" b="0" i="0" u="none" strike="noStrike" baseline="0">
                    <a:effectLst/>
                  </a:rPr>
                  <a:t>(x 10^2) </a:t>
                </a:r>
                <a:endParaRPr lang="en-GB"/>
              </a:p>
            </c:rich>
          </c:tx>
          <c:layout>
            <c:manualLayout>
              <c:xMode val="edge"/>
              <c:yMode val="edge"/>
              <c:x val="0.96723353299592907"/>
              <c:y val="0.3558178395937793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  <a:prstDash val="sysDot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810576"/>
        <c:crosses val="max"/>
        <c:crossBetween val="midCat"/>
      </c:valAx>
      <c:valAx>
        <c:axId val="193810576"/>
        <c:scaling>
          <c:orientation val="minMax"/>
          <c:max val="24"/>
          <c:min val="0"/>
        </c:scaling>
        <c:delete val="1"/>
        <c:axPos val="t"/>
        <c:numFmt formatCode="0.00" sourceLinked="1"/>
        <c:majorTickMark val="out"/>
        <c:minorTickMark val="none"/>
        <c:tickLblPos val="nextTo"/>
        <c:crossAx val="207755872"/>
        <c:crosses val="max"/>
        <c:crossBetween val="midCat"/>
        <c:majorUnit val="4"/>
      </c:valAx>
    </c:plotArea>
    <c:legend>
      <c:legendPos val="l"/>
      <c:layout>
        <c:manualLayout>
          <c:xMode val="edge"/>
          <c:yMode val="edge"/>
          <c:x val="0.13259258574827659"/>
          <c:y val="2.5270915093177401E-2"/>
          <c:w val="0.24774521371611433"/>
          <c:h val="0.1267740664637123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b="1"/>
              <a:t>5-(Hydroxyphenyl)-gamma-valerolactone </a:t>
            </a: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0409953867867502"/>
          <c:y val="5.1549654467208252E-2"/>
          <c:w val="0.8137110249163827"/>
          <c:h val="0.83488085096061249"/>
        </c:manualLayout>
      </c:layout>
      <c:scatterChart>
        <c:scatterStyle val="smoothMarker"/>
        <c:varyColors val="0"/>
        <c:ser>
          <c:idx val="1"/>
          <c:order val="0"/>
          <c:tx>
            <c:strRef>
              <c:f>Data!$B$5</c:f>
              <c:strCache>
                <c:ptCount val="1"/>
                <c:pt idx="0">
                  <c:v>Older females</c:v>
                </c:pt>
              </c:strCache>
            </c:strRef>
          </c:tx>
          <c:spPr>
            <a:ln w="2222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squar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35:$A$38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B$35:$B$38</c:f>
              <c:numCache>
                <c:formatCode>General</c:formatCode>
                <c:ptCount val="4"/>
                <c:pt idx="0">
                  <c:v>9.9761538606185515E-2</c:v>
                </c:pt>
                <c:pt idx="1">
                  <c:v>0.41836723617581212</c:v>
                </c:pt>
                <c:pt idx="2">
                  <c:v>1.9660470741232405</c:v>
                </c:pt>
                <c:pt idx="3">
                  <c:v>2.397320278104016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E764-5748-877A-A58C90877A81}"/>
            </c:ext>
          </c:extLst>
        </c:ser>
        <c:ser>
          <c:idx val="0"/>
          <c:order val="1"/>
          <c:tx>
            <c:strRef>
              <c:f>Data!$C$5</c:f>
              <c:strCache>
                <c:ptCount val="1"/>
                <c:pt idx="0">
                  <c:v>Older males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C$35:$C$38</c:f>
              <c:numCache>
                <c:formatCode>General</c:formatCode>
                <c:ptCount val="4"/>
                <c:pt idx="0">
                  <c:v>9.5694383961256138E-2</c:v>
                </c:pt>
                <c:pt idx="1">
                  <c:v>0.49932896537628318</c:v>
                </c:pt>
                <c:pt idx="2">
                  <c:v>1.3236514223261666</c:v>
                </c:pt>
                <c:pt idx="3">
                  <c:v>2.186425692081964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E764-5748-877A-A58C90877A81}"/>
            </c:ext>
          </c:extLst>
        </c:ser>
        <c:ser>
          <c:idx val="2"/>
          <c:order val="2"/>
          <c:tx>
            <c:strRef>
              <c:f>Data!$D$5</c:f>
              <c:strCache>
                <c:ptCount val="1"/>
                <c:pt idx="0">
                  <c:v>Younger females</c:v>
                </c:pt>
              </c:strCache>
            </c:strRef>
          </c:tx>
          <c:spPr>
            <a:ln w="2222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triang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D$35:$D$38</c:f>
              <c:numCache>
                <c:formatCode>General</c:formatCode>
                <c:ptCount val="4"/>
                <c:pt idx="0">
                  <c:v>9.9979297097195732E-2</c:v>
                </c:pt>
                <c:pt idx="1">
                  <c:v>0.64605814834413555</c:v>
                </c:pt>
                <c:pt idx="2">
                  <c:v>2.9235508241635224</c:v>
                </c:pt>
                <c:pt idx="3">
                  <c:v>4.056232181444227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E764-5748-877A-A58C90877A81}"/>
            </c:ext>
          </c:extLst>
        </c:ser>
        <c:ser>
          <c:idx val="3"/>
          <c:order val="3"/>
          <c:tx>
            <c:strRef>
              <c:f>Data!$E$5</c:f>
              <c:strCache>
                <c:ptCount val="1"/>
                <c:pt idx="0">
                  <c:v>Younger males</c:v>
                </c:pt>
              </c:strCache>
            </c:strRef>
          </c:tx>
          <c:spPr>
            <a:ln w="12700" cap="rnd">
              <a:solidFill>
                <a:schemeClr val="tx1"/>
              </a:solidFill>
              <a:prstDash val="lgDashDotDot"/>
              <a:round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E$35:$E$38</c:f>
              <c:numCache>
                <c:formatCode>General</c:formatCode>
                <c:ptCount val="4"/>
                <c:pt idx="0">
                  <c:v>9.4917342103139415E-2</c:v>
                </c:pt>
                <c:pt idx="1">
                  <c:v>0.57575536805697325</c:v>
                </c:pt>
                <c:pt idx="2">
                  <c:v>1.1582867736176126</c:v>
                </c:pt>
                <c:pt idx="3">
                  <c:v>1.392871166006214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E764-5748-877A-A58C90877A8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2032112"/>
        <c:axId val="181721936"/>
      </c:scatterChart>
      <c:scatterChart>
        <c:scatterStyle val="lineMarker"/>
        <c:varyColors val="0"/>
        <c:ser>
          <c:idx val="4"/>
          <c:order val="4"/>
          <c:tx>
            <c:strRef>
              <c:f>Data!$F$5</c:f>
              <c:strCache>
                <c:ptCount val="1"/>
                <c:pt idx="0">
                  <c:v>Tmax/ Cmax (secondary axis)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x"/>
            <c:size val="6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dLbls>
            <c:dLbl>
              <c:idx val="0"/>
              <c:layout>
                <c:manualLayout>
                  <c:x val="-0.11598131148379377"/>
                  <c:y val="-1.0458452438911109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older fe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E764-5748-877A-A58C90877A81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/>
                      <a:t>older 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E764-5748-877A-A58C90877A81}"/>
                </c:ext>
              </c:extLst>
            </c:dLbl>
            <c:dLbl>
              <c:idx val="2"/>
              <c:layout>
                <c:manualLayout>
                  <c:x val="-0.13508411572818332"/>
                  <c:y val="-6.275071463346665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younger fe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E764-5748-877A-A58C90877A81}"/>
                </c:ext>
              </c:extLst>
            </c:dLbl>
            <c:dLbl>
              <c:idx val="3"/>
              <c:layout>
                <c:manualLayout>
                  <c:x val="1.3644860174563962E-3"/>
                  <c:y val="0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younger 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E764-5748-877A-A58C90877A81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Data!$G$35:$G$38</c:f>
              <c:numCache>
                <c:formatCode>0.00</c:formatCode>
                <c:ptCount val="4"/>
                <c:pt idx="0">
                  <c:v>15.374999999999998</c:v>
                </c:pt>
                <c:pt idx="1">
                  <c:v>17.836956521739133</c:v>
                </c:pt>
                <c:pt idx="2">
                  <c:v>15.869047619047619</c:v>
                </c:pt>
                <c:pt idx="3">
                  <c:v>13.967741935483872</c:v>
                </c:pt>
              </c:numCache>
            </c:numRef>
          </c:xVal>
          <c:yVal>
            <c:numRef>
              <c:f>Data!$I$35:$I$38</c:f>
              <c:numCache>
                <c:formatCode>General</c:formatCode>
                <c:ptCount val="4"/>
                <c:pt idx="0">
                  <c:v>10.51706841522406</c:v>
                </c:pt>
                <c:pt idx="1">
                  <c:v>14.652489607586801</c:v>
                </c:pt>
                <c:pt idx="2">
                  <c:v>21.392460844834293</c:v>
                </c:pt>
                <c:pt idx="3">
                  <c:v>5.111118496936410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E764-5748-877A-A58C90877A8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3810576"/>
        <c:axId val="207755872"/>
      </c:scatterChart>
      <c:valAx>
        <c:axId val="182032112"/>
        <c:scaling>
          <c:orientation val="minMax"/>
          <c:max val="2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Time (hours)</a:t>
                </a:r>
              </a:p>
            </c:rich>
          </c:tx>
          <c:layout>
            <c:manualLayout>
              <c:xMode val="edge"/>
              <c:yMode val="edge"/>
              <c:x val="0.46761979600830411"/>
              <c:y val="0.94242507153449318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1721936"/>
        <c:crosses val="autoZero"/>
        <c:crossBetween val="midCat"/>
        <c:majorUnit val="4"/>
      </c:valAx>
      <c:valAx>
        <c:axId val="1817219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>
                    <a:solidFill>
                      <a:schemeClr val="tx1"/>
                    </a:solidFill>
                  </a:rPr>
                  <a:t>Cumulative</a:t>
                </a:r>
                <a:r>
                  <a:rPr lang="en-GB" baseline="0">
                    <a:solidFill>
                      <a:schemeClr val="tx1"/>
                    </a:solidFill>
                  </a:rPr>
                  <a:t> c</a:t>
                </a:r>
                <a:r>
                  <a:rPr lang="en-GB">
                    <a:solidFill>
                      <a:schemeClr val="tx1"/>
                    </a:solidFill>
                  </a:rPr>
                  <a:t>oncentration </a:t>
                </a:r>
                <a:r>
                  <a:rPr lang="en-GB" sz="1100" b="0" i="0" u="none" strike="noStrike" baseline="0">
                    <a:effectLst/>
                  </a:rPr>
                  <a:t>(x 10^2) </a:t>
                </a:r>
                <a:endParaRPr lang="en-GB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1.5616992582602829E-2"/>
              <c:y val="0.3611130140562668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2032112"/>
        <c:crosses val="autoZero"/>
        <c:crossBetween val="midCat"/>
      </c:valAx>
      <c:valAx>
        <c:axId val="207755872"/>
        <c:scaling>
          <c:orientation val="minMax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Maximum concentration </a:t>
                </a:r>
                <a:r>
                  <a:rPr lang="en-GB" sz="1100" b="0" i="0" u="none" strike="noStrike" baseline="0">
                    <a:effectLst/>
                  </a:rPr>
                  <a:t>(x 10^2) </a:t>
                </a:r>
                <a:endParaRPr lang="en-GB"/>
              </a:p>
            </c:rich>
          </c:tx>
          <c:layout>
            <c:manualLayout>
              <c:xMode val="edge"/>
              <c:yMode val="edge"/>
              <c:x val="0.96723353299592907"/>
              <c:y val="0.3558178395937793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  <a:prstDash val="sysDot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810576"/>
        <c:crosses val="max"/>
        <c:crossBetween val="midCat"/>
      </c:valAx>
      <c:valAx>
        <c:axId val="193810576"/>
        <c:scaling>
          <c:orientation val="minMax"/>
          <c:max val="24"/>
          <c:min val="0"/>
        </c:scaling>
        <c:delete val="1"/>
        <c:axPos val="t"/>
        <c:numFmt formatCode="0.00" sourceLinked="1"/>
        <c:majorTickMark val="out"/>
        <c:minorTickMark val="none"/>
        <c:tickLblPos val="nextTo"/>
        <c:crossAx val="207755872"/>
        <c:crosses val="max"/>
        <c:crossBetween val="midCat"/>
        <c:majorUnit val="4"/>
      </c:valAx>
    </c:plotArea>
    <c:legend>
      <c:legendPos val="l"/>
      <c:layout>
        <c:manualLayout>
          <c:xMode val="edge"/>
          <c:yMode val="edge"/>
          <c:x val="0.6565552164515327"/>
          <c:y val="2.5270915093177401E-2"/>
          <c:w val="0.24774521371611433"/>
          <c:h val="0.1267740664637123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b="1" dirty="0"/>
              <a:t>Hesperetin-3'-</a:t>
            </a:r>
            <a:r>
              <a:rPr lang="en-GB" b="1" i="1" dirty="0"/>
              <a:t>O</a:t>
            </a:r>
            <a:r>
              <a:rPr lang="en-GB" b="1" dirty="0"/>
              <a:t>-glucuronide</a:t>
            </a: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0409953867867502"/>
          <c:y val="5.1549654467208252E-2"/>
          <c:w val="0.8137110249163827"/>
          <c:h val="0.83488085096061249"/>
        </c:manualLayout>
      </c:layout>
      <c:scatterChart>
        <c:scatterStyle val="smoothMarker"/>
        <c:varyColors val="0"/>
        <c:ser>
          <c:idx val="1"/>
          <c:order val="0"/>
          <c:tx>
            <c:strRef>
              <c:f>Data!$B$5</c:f>
              <c:strCache>
                <c:ptCount val="1"/>
                <c:pt idx="0">
                  <c:v>Older females</c:v>
                </c:pt>
              </c:strCache>
            </c:strRef>
          </c:tx>
          <c:spPr>
            <a:ln w="2222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squar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B$42:$B$45</c:f>
              <c:numCache>
                <c:formatCode>General</c:formatCode>
                <c:ptCount val="4"/>
                <c:pt idx="0">
                  <c:v>2.3160422834073119E-3</c:v>
                </c:pt>
                <c:pt idx="1">
                  <c:v>5.7748889974267845E-2</c:v>
                </c:pt>
                <c:pt idx="2">
                  <c:v>0.43810274876481187</c:v>
                </c:pt>
                <c:pt idx="3">
                  <c:v>0.5173874342870309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D1BD-8540-9CF6-9179799F06BB}"/>
            </c:ext>
          </c:extLst>
        </c:ser>
        <c:ser>
          <c:idx val="0"/>
          <c:order val="1"/>
          <c:tx>
            <c:strRef>
              <c:f>Data!$C$5</c:f>
              <c:strCache>
                <c:ptCount val="1"/>
                <c:pt idx="0">
                  <c:v>Older males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C$42:$C$45</c:f>
              <c:numCache>
                <c:formatCode>General</c:formatCode>
                <c:ptCount val="4"/>
                <c:pt idx="0">
                  <c:v>4.7414302632360922E-3</c:v>
                </c:pt>
                <c:pt idx="1">
                  <c:v>4.2738088961275476E-2</c:v>
                </c:pt>
                <c:pt idx="2">
                  <c:v>0.67341448525449554</c:v>
                </c:pt>
                <c:pt idx="3">
                  <c:v>0.7722046245202620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D1BD-8540-9CF6-9179799F06BB}"/>
            </c:ext>
          </c:extLst>
        </c:ser>
        <c:ser>
          <c:idx val="2"/>
          <c:order val="2"/>
          <c:tx>
            <c:strRef>
              <c:f>Data!$D$5</c:f>
              <c:strCache>
                <c:ptCount val="1"/>
                <c:pt idx="0">
                  <c:v>Younger females</c:v>
                </c:pt>
              </c:strCache>
            </c:strRef>
          </c:tx>
          <c:spPr>
            <a:ln w="2222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triang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D$42:$D$45</c:f>
              <c:numCache>
                <c:formatCode>General</c:formatCode>
                <c:ptCount val="4"/>
                <c:pt idx="0">
                  <c:v>3.3450021082677681E-3</c:v>
                </c:pt>
                <c:pt idx="1">
                  <c:v>7.9828010588066503E-2</c:v>
                </c:pt>
                <c:pt idx="2">
                  <c:v>0.51365350314029778</c:v>
                </c:pt>
                <c:pt idx="3">
                  <c:v>0.5673077413585122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D1BD-8540-9CF6-9179799F06BB}"/>
            </c:ext>
          </c:extLst>
        </c:ser>
        <c:ser>
          <c:idx val="3"/>
          <c:order val="3"/>
          <c:tx>
            <c:strRef>
              <c:f>Data!$E$5</c:f>
              <c:strCache>
                <c:ptCount val="1"/>
                <c:pt idx="0">
                  <c:v>Younger males</c:v>
                </c:pt>
              </c:strCache>
            </c:strRef>
          </c:tx>
          <c:spPr>
            <a:ln w="12700" cap="rnd">
              <a:solidFill>
                <a:schemeClr val="tx1"/>
              </a:solidFill>
              <a:prstDash val="lgDashDotDot"/>
              <a:round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E$42:$E$45</c:f>
              <c:numCache>
                <c:formatCode>General</c:formatCode>
                <c:ptCount val="4"/>
                <c:pt idx="0">
                  <c:v>3.3518437140307848E-3</c:v>
                </c:pt>
                <c:pt idx="1">
                  <c:v>6.2167939221511627E-2</c:v>
                </c:pt>
                <c:pt idx="2">
                  <c:v>0.2932941648195902</c:v>
                </c:pt>
                <c:pt idx="3">
                  <c:v>0.3556845642954824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D1BD-8540-9CF6-9179799F06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2032112"/>
        <c:axId val="181721936"/>
      </c:scatterChart>
      <c:scatterChart>
        <c:scatterStyle val="lineMarker"/>
        <c:varyColors val="0"/>
        <c:ser>
          <c:idx val="4"/>
          <c:order val="4"/>
          <c:tx>
            <c:strRef>
              <c:f>Data!$F$5</c:f>
              <c:strCache>
                <c:ptCount val="1"/>
                <c:pt idx="0">
                  <c:v>Tmax/ Cmax (secondary axis)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x"/>
            <c:size val="6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dLbls>
            <c:dLbl>
              <c:idx val="0"/>
              <c:layout>
                <c:manualLayout>
                  <c:x val="4.0934580523690886E-3"/>
                  <c:y val="8.3667619511288878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older fe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4-D1BD-8540-9CF6-9179799F06BB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/>
                      <a:t>older 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5-D1BD-8540-9CF6-9179799F06BB}"/>
                </c:ext>
              </c:extLst>
            </c:dLbl>
            <c:dLbl>
              <c:idx val="2"/>
              <c:layout>
                <c:manualLayout>
                  <c:x val="1.3644860174563962E-3"/>
                  <c:y val="2.0916904877822219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younger fe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6-D1BD-8540-9CF6-9179799F06BB}"/>
                </c:ext>
              </c:extLst>
            </c:dLbl>
            <c:dLbl>
              <c:idx val="3"/>
              <c:layout>
                <c:manualLayout>
                  <c:x val="6.8224300872819802E-3"/>
                  <c:y val="0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younger 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7-D1BD-8540-9CF6-9179799F06B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xVal>
            <c:numRef>
              <c:f>Data!$G$42:$G$45</c:f>
              <c:numCache>
                <c:formatCode>0.00</c:formatCode>
                <c:ptCount val="4"/>
                <c:pt idx="0">
                  <c:v>15.034090909090908</c:v>
                </c:pt>
                <c:pt idx="1">
                  <c:v>16.456521739130434</c:v>
                </c:pt>
                <c:pt idx="2">
                  <c:v>11.928571428571427</c:v>
                </c:pt>
                <c:pt idx="3">
                  <c:v>15.774193548387096</c:v>
                </c:pt>
              </c:numCache>
            </c:numRef>
          </c:xVal>
          <c:yVal>
            <c:numRef>
              <c:f>Data!$F$42:$F$45</c:f>
              <c:numCache>
                <c:formatCode>0.00</c:formatCode>
                <c:ptCount val="4"/>
                <c:pt idx="0">
                  <c:v>1.7718576160682877</c:v>
                </c:pt>
                <c:pt idx="1">
                  <c:v>2.7870177480837572</c:v>
                </c:pt>
                <c:pt idx="2">
                  <c:v>1.6420355918930791</c:v>
                </c:pt>
                <c:pt idx="3">
                  <c:v>1.202616009981400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D1BD-8540-9CF6-9179799F06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3810576"/>
        <c:axId val="207755872"/>
      </c:scatterChart>
      <c:valAx>
        <c:axId val="182032112"/>
        <c:scaling>
          <c:orientation val="minMax"/>
          <c:max val="2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Time (hours)</a:t>
                </a:r>
              </a:p>
            </c:rich>
          </c:tx>
          <c:layout>
            <c:manualLayout>
              <c:xMode val="edge"/>
              <c:yMode val="edge"/>
              <c:x val="0.46761979600830411"/>
              <c:y val="0.94242507153449318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1721936"/>
        <c:crosses val="autoZero"/>
        <c:crossBetween val="midCat"/>
        <c:majorUnit val="4"/>
      </c:valAx>
      <c:valAx>
        <c:axId val="1817219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>
                    <a:solidFill>
                      <a:schemeClr val="tx1"/>
                    </a:solidFill>
                  </a:rPr>
                  <a:t>Cumulative</a:t>
                </a:r>
                <a:r>
                  <a:rPr lang="en-GB" baseline="0">
                    <a:solidFill>
                      <a:schemeClr val="tx1"/>
                    </a:solidFill>
                  </a:rPr>
                  <a:t> c</a:t>
                </a:r>
                <a:r>
                  <a:rPr lang="en-GB">
                    <a:solidFill>
                      <a:schemeClr val="tx1"/>
                    </a:solidFill>
                  </a:rPr>
                  <a:t>oncentration</a:t>
                </a:r>
              </a:p>
            </c:rich>
          </c:tx>
          <c:layout>
            <c:manualLayout>
              <c:xMode val="edge"/>
              <c:yMode val="edge"/>
              <c:x val="1.5616992582602829E-2"/>
              <c:y val="0.3611130140562668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2032112"/>
        <c:crosses val="autoZero"/>
        <c:crossBetween val="midCat"/>
      </c:valAx>
      <c:valAx>
        <c:axId val="207755872"/>
        <c:scaling>
          <c:orientation val="minMax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Maximum concentration</a:t>
                </a:r>
              </a:p>
            </c:rich>
          </c:tx>
          <c:layout>
            <c:manualLayout>
              <c:xMode val="edge"/>
              <c:yMode val="edge"/>
              <c:x val="0.96723353299592907"/>
              <c:y val="0.3558178395937793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  <a:prstDash val="sysDot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810576"/>
        <c:crosses val="max"/>
        <c:crossBetween val="midCat"/>
      </c:valAx>
      <c:valAx>
        <c:axId val="193810576"/>
        <c:scaling>
          <c:orientation val="minMax"/>
          <c:max val="24"/>
          <c:min val="0"/>
        </c:scaling>
        <c:delete val="1"/>
        <c:axPos val="t"/>
        <c:numFmt formatCode="0.00" sourceLinked="1"/>
        <c:majorTickMark val="out"/>
        <c:minorTickMark val="none"/>
        <c:tickLblPos val="nextTo"/>
        <c:crossAx val="207755872"/>
        <c:crosses val="max"/>
        <c:crossBetween val="midCat"/>
        <c:majorUnit val="4"/>
      </c:valAx>
    </c:plotArea>
    <c:legend>
      <c:legendPos val="l"/>
      <c:layout>
        <c:manualLayout>
          <c:xMode val="edge"/>
          <c:yMode val="edge"/>
          <c:x val="0.12031221159116902"/>
          <c:y val="2.5270915093177401E-2"/>
          <c:w val="0.24774521371611433"/>
          <c:h val="0.1267740664637123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b="1" dirty="0"/>
              <a:t>Hesperetin-7'-sulfate</a:t>
            </a: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040995391475336"/>
          <c:y val="5.3641320209155879E-2"/>
          <c:w val="0.8137110249163827"/>
          <c:h val="0.83488085096061249"/>
        </c:manualLayout>
      </c:layout>
      <c:scatterChart>
        <c:scatterStyle val="smoothMarker"/>
        <c:varyColors val="0"/>
        <c:ser>
          <c:idx val="1"/>
          <c:order val="0"/>
          <c:tx>
            <c:strRef>
              <c:f>Data!$B$5</c:f>
              <c:strCache>
                <c:ptCount val="1"/>
                <c:pt idx="0">
                  <c:v>Older females</c:v>
                </c:pt>
              </c:strCache>
            </c:strRef>
          </c:tx>
          <c:spPr>
            <a:ln w="2222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squar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35:$A$38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B$49:$B$52</c:f>
              <c:numCache>
                <c:formatCode>General</c:formatCode>
                <c:ptCount val="4"/>
                <c:pt idx="0">
                  <c:v>1.4579030236680396E-2</c:v>
                </c:pt>
                <c:pt idx="1">
                  <c:v>7.7240868240385702E-2</c:v>
                </c:pt>
                <c:pt idx="2">
                  <c:v>0.1351334256194768</c:v>
                </c:pt>
                <c:pt idx="3">
                  <c:v>0.134532279288525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222C-A543-8667-C809FE6B4473}"/>
            </c:ext>
          </c:extLst>
        </c:ser>
        <c:ser>
          <c:idx val="0"/>
          <c:order val="1"/>
          <c:tx>
            <c:strRef>
              <c:f>Data!$C$5</c:f>
              <c:strCache>
                <c:ptCount val="1"/>
                <c:pt idx="0">
                  <c:v>Older males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C$49:$C$52</c:f>
              <c:numCache>
                <c:formatCode>General</c:formatCode>
                <c:ptCount val="4"/>
                <c:pt idx="0">
                  <c:v>1.7506445278182819E-2</c:v>
                </c:pt>
                <c:pt idx="1">
                  <c:v>5.9689186100907676E-2</c:v>
                </c:pt>
                <c:pt idx="2">
                  <c:v>0.16231912806132262</c:v>
                </c:pt>
                <c:pt idx="3">
                  <c:v>0.1994748194313808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222C-A543-8667-C809FE6B4473}"/>
            </c:ext>
          </c:extLst>
        </c:ser>
        <c:ser>
          <c:idx val="2"/>
          <c:order val="2"/>
          <c:tx>
            <c:strRef>
              <c:f>Data!$D$5</c:f>
              <c:strCache>
                <c:ptCount val="1"/>
                <c:pt idx="0">
                  <c:v>Younger females</c:v>
                </c:pt>
              </c:strCache>
            </c:strRef>
          </c:tx>
          <c:spPr>
            <a:ln w="2222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triang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D$49:$D$52</c:f>
              <c:numCache>
                <c:formatCode>General</c:formatCode>
                <c:ptCount val="4"/>
                <c:pt idx="0">
                  <c:v>1.5375335344685877E-2</c:v>
                </c:pt>
                <c:pt idx="1">
                  <c:v>8.2282935173049729E-2</c:v>
                </c:pt>
                <c:pt idx="2">
                  <c:v>0.14876544599921757</c:v>
                </c:pt>
                <c:pt idx="3">
                  <c:v>0.1579349266715266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222C-A543-8667-C809FE6B4473}"/>
            </c:ext>
          </c:extLst>
        </c:ser>
        <c:ser>
          <c:idx val="3"/>
          <c:order val="3"/>
          <c:tx>
            <c:strRef>
              <c:f>Data!$E$5</c:f>
              <c:strCache>
                <c:ptCount val="1"/>
                <c:pt idx="0">
                  <c:v>Younger males</c:v>
                </c:pt>
              </c:strCache>
            </c:strRef>
          </c:tx>
          <c:spPr>
            <a:ln w="12700" cap="rnd">
              <a:solidFill>
                <a:schemeClr val="tx1"/>
              </a:solidFill>
              <a:prstDash val="lgDashDotDot"/>
              <a:round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E$49:$E$52</c:f>
              <c:numCache>
                <c:formatCode>General</c:formatCode>
                <c:ptCount val="4"/>
                <c:pt idx="0">
                  <c:v>1.0175964289714722E-2</c:v>
                </c:pt>
                <c:pt idx="1">
                  <c:v>4.3826463164154707E-2</c:v>
                </c:pt>
                <c:pt idx="2">
                  <c:v>6.2609881879617801E-2</c:v>
                </c:pt>
                <c:pt idx="3">
                  <c:v>6.9656724124149028E-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222C-A543-8667-C809FE6B447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2032112"/>
        <c:axId val="181721936"/>
      </c:scatterChart>
      <c:scatterChart>
        <c:scatterStyle val="lineMarker"/>
        <c:varyColors val="0"/>
        <c:ser>
          <c:idx val="4"/>
          <c:order val="4"/>
          <c:tx>
            <c:strRef>
              <c:f>Data!$F$5</c:f>
              <c:strCache>
                <c:ptCount val="1"/>
                <c:pt idx="0">
                  <c:v>Tmax/ Cmax (secondary axis)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x"/>
            <c:size val="6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dLbls>
            <c:dLbl>
              <c:idx val="0"/>
              <c:layout>
                <c:manualLayout>
                  <c:x val="2.7289720349127924E-3"/>
                  <c:y val="0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older fe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4-222C-A543-8667-C809FE6B4473}"/>
                </c:ext>
              </c:extLst>
            </c:dLbl>
            <c:dLbl>
              <c:idx val="1"/>
              <c:layout>
                <c:manualLayout>
                  <c:x val="-0.1037009373266861"/>
                  <c:y val="-4.1833809755645202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older 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5-222C-A543-8667-C809FE6B4473}"/>
                </c:ext>
              </c:extLst>
            </c:dLbl>
            <c:dLbl>
              <c:idx val="2"/>
              <c:layout>
                <c:manualLayout>
                  <c:x val="1.3644860174564211E-3"/>
                  <c:y val="-8.3667619511288878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younger fe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6-222C-A543-8667-C809FE6B4473}"/>
                </c:ext>
              </c:extLst>
            </c:dLbl>
            <c:dLbl>
              <c:idx val="3"/>
              <c:layout>
                <c:manualLayout>
                  <c:x val="3.5476636453866298E-2"/>
                  <c:y val="1.4641833414475398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younger 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7-222C-A543-8667-C809FE6B447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Data!$G$49:$G$52</c:f>
              <c:numCache>
                <c:formatCode>0.00</c:formatCode>
                <c:ptCount val="4"/>
                <c:pt idx="0">
                  <c:v>5.9318181818181799</c:v>
                </c:pt>
                <c:pt idx="1">
                  <c:v>5.5326086956521738</c:v>
                </c:pt>
                <c:pt idx="2">
                  <c:v>2.2261904761904767</c:v>
                </c:pt>
                <c:pt idx="3">
                  <c:v>3.1129032258064515</c:v>
                </c:pt>
              </c:numCache>
            </c:numRef>
          </c:xVal>
          <c:yVal>
            <c:numRef>
              <c:f>Data!$I$35:$I$38</c:f>
              <c:numCache>
                <c:formatCode>General</c:formatCode>
                <c:ptCount val="4"/>
                <c:pt idx="0">
                  <c:v>10.51706841522406</c:v>
                </c:pt>
                <c:pt idx="1">
                  <c:v>14.652489607586801</c:v>
                </c:pt>
                <c:pt idx="2">
                  <c:v>21.392460844834293</c:v>
                </c:pt>
                <c:pt idx="3">
                  <c:v>5.111118496936410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222C-A543-8667-C809FE6B447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3810576"/>
        <c:axId val="207755872"/>
      </c:scatterChart>
      <c:valAx>
        <c:axId val="182032112"/>
        <c:scaling>
          <c:orientation val="minMax"/>
          <c:max val="2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Time (hours)</a:t>
                </a:r>
              </a:p>
            </c:rich>
          </c:tx>
          <c:layout>
            <c:manualLayout>
              <c:xMode val="edge"/>
              <c:yMode val="edge"/>
              <c:x val="0.46761979600830411"/>
              <c:y val="0.94242507153449318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1721936"/>
        <c:crosses val="autoZero"/>
        <c:crossBetween val="midCat"/>
        <c:majorUnit val="4"/>
      </c:valAx>
      <c:valAx>
        <c:axId val="1817219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>
                    <a:solidFill>
                      <a:schemeClr val="tx1"/>
                    </a:solidFill>
                  </a:rPr>
                  <a:t>Cumulative</a:t>
                </a:r>
                <a:r>
                  <a:rPr lang="en-GB" baseline="0">
                    <a:solidFill>
                      <a:schemeClr val="tx1"/>
                    </a:solidFill>
                  </a:rPr>
                  <a:t> c</a:t>
                </a:r>
                <a:r>
                  <a:rPr lang="en-GB">
                    <a:solidFill>
                      <a:schemeClr val="tx1"/>
                    </a:solidFill>
                  </a:rPr>
                  <a:t>oncentration </a:t>
                </a:r>
                <a:r>
                  <a:rPr lang="en-GB" sz="1100" b="0" i="0" u="none" strike="noStrike" baseline="0">
                    <a:effectLst/>
                  </a:rPr>
                  <a:t>(x 10^2) </a:t>
                </a:r>
                <a:endParaRPr lang="en-GB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1.5616992582602829E-2"/>
              <c:y val="0.3611130140562668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.0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2032112"/>
        <c:crosses val="autoZero"/>
        <c:crossBetween val="midCat"/>
      </c:valAx>
      <c:valAx>
        <c:axId val="207755872"/>
        <c:scaling>
          <c:orientation val="minMax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Maximum concentration </a:t>
                </a:r>
                <a:r>
                  <a:rPr lang="en-GB" sz="1100" b="0" i="0" u="none" strike="noStrike" baseline="0">
                    <a:effectLst/>
                  </a:rPr>
                  <a:t>(x 10^2) </a:t>
                </a:r>
                <a:endParaRPr lang="en-GB"/>
              </a:p>
            </c:rich>
          </c:tx>
          <c:layout>
            <c:manualLayout>
              <c:xMode val="edge"/>
              <c:yMode val="edge"/>
              <c:x val="0.96723353299592907"/>
              <c:y val="0.3558178395937793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  <a:prstDash val="sysDot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810576"/>
        <c:crosses val="max"/>
        <c:crossBetween val="midCat"/>
      </c:valAx>
      <c:valAx>
        <c:axId val="193810576"/>
        <c:scaling>
          <c:orientation val="minMax"/>
          <c:max val="24"/>
          <c:min val="0"/>
        </c:scaling>
        <c:delete val="1"/>
        <c:axPos val="t"/>
        <c:numFmt formatCode="0.00" sourceLinked="1"/>
        <c:majorTickMark val="out"/>
        <c:minorTickMark val="none"/>
        <c:tickLblPos val="nextTo"/>
        <c:crossAx val="207755872"/>
        <c:crosses val="max"/>
        <c:crossBetween val="midCat"/>
        <c:majorUnit val="4"/>
      </c:valAx>
    </c:plotArea>
    <c:legend>
      <c:legendPos val="l"/>
      <c:layout>
        <c:manualLayout>
          <c:xMode val="edge"/>
          <c:yMode val="edge"/>
          <c:x val="0.6565552164515327"/>
          <c:y val="2.5270915093177401E-2"/>
          <c:w val="0.24774521371611433"/>
          <c:h val="0.1267740664637123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b="1" dirty="0" smtClean="0"/>
              <a:t>Cyanidin-3-</a:t>
            </a:r>
            <a:r>
              <a:rPr lang="en-GB" b="1" i="1" dirty="0" smtClean="0"/>
              <a:t>O</a:t>
            </a:r>
            <a:r>
              <a:rPr lang="en-GB" b="1" dirty="0" smtClean="0"/>
              <a:t>-glucoside</a:t>
            </a:r>
            <a:endParaRPr lang="en-GB" b="1" dirty="0"/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0409953867867502"/>
          <c:y val="5.1549654467208252E-2"/>
          <c:w val="0.8137110249163827"/>
          <c:h val="0.83488085096061249"/>
        </c:manualLayout>
      </c:layout>
      <c:scatterChart>
        <c:scatterStyle val="smoothMarker"/>
        <c:varyColors val="0"/>
        <c:ser>
          <c:idx val="1"/>
          <c:order val="0"/>
          <c:tx>
            <c:strRef>
              <c:f>Data!$B$5</c:f>
              <c:strCache>
                <c:ptCount val="1"/>
                <c:pt idx="0">
                  <c:v>Older females</c:v>
                </c:pt>
              </c:strCache>
            </c:strRef>
          </c:tx>
          <c:spPr>
            <a:ln w="2222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squar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B$56:$B$59</c:f>
              <c:numCache>
                <c:formatCode>0.000</c:formatCode>
                <c:ptCount val="4"/>
                <c:pt idx="0">
                  <c:v>2.0741082281472974E-2</c:v>
                </c:pt>
                <c:pt idx="1">
                  <c:v>7.9084242059556234E-2</c:v>
                </c:pt>
                <c:pt idx="2">
                  <c:v>0.12927785198401928</c:v>
                </c:pt>
                <c:pt idx="3">
                  <c:v>9.2195610015775753E-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C635-2144-9361-5CC54751EE96}"/>
            </c:ext>
          </c:extLst>
        </c:ser>
        <c:ser>
          <c:idx val="0"/>
          <c:order val="1"/>
          <c:tx>
            <c:strRef>
              <c:f>Data!$C$5</c:f>
              <c:strCache>
                <c:ptCount val="1"/>
                <c:pt idx="0">
                  <c:v>Older males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C$56:$C$59</c:f>
              <c:numCache>
                <c:formatCode>0.000</c:formatCode>
                <c:ptCount val="4"/>
                <c:pt idx="0">
                  <c:v>6.1018790912917842E-3</c:v>
                </c:pt>
                <c:pt idx="1">
                  <c:v>2.8274911721029476E-2</c:v>
                </c:pt>
                <c:pt idx="2">
                  <c:v>3.1680970637343847E-2</c:v>
                </c:pt>
                <c:pt idx="3">
                  <c:v>3.2285005005579265E-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C635-2144-9361-5CC54751EE96}"/>
            </c:ext>
          </c:extLst>
        </c:ser>
        <c:ser>
          <c:idx val="2"/>
          <c:order val="2"/>
          <c:tx>
            <c:strRef>
              <c:f>Data!$D$5</c:f>
              <c:strCache>
                <c:ptCount val="1"/>
                <c:pt idx="0">
                  <c:v>Younger females</c:v>
                </c:pt>
              </c:strCache>
            </c:strRef>
          </c:tx>
          <c:spPr>
            <a:ln w="2222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triang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D$56:$D$59</c:f>
              <c:numCache>
                <c:formatCode>0.000</c:formatCode>
                <c:ptCount val="4"/>
                <c:pt idx="0">
                  <c:v>2.4051804166862396E-3</c:v>
                </c:pt>
                <c:pt idx="1">
                  <c:v>0.15840086079837254</c:v>
                </c:pt>
                <c:pt idx="2">
                  <c:v>0.16757253071141415</c:v>
                </c:pt>
                <c:pt idx="3">
                  <c:v>0.1678983037421397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C635-2144-9361-5CC54751EE96}"/>
            </c:ext>
          </c:extLst>
        </c:ser>
        <c:ser>
          <c:idx val="3"/>
          <c:order val="3"/>
          <c:tx>
            <c:strRef>
              <c:f>Data!$E$5</c:f>
              <c:strCache>
                <c:ptCount val="1"/>
                <c:pt idx="0">
                  <c:v>Younger males</c:v>
                </c:pt>
              </c:strCache>
            </c:strRef>
          </c:tx>
          <c:spPr>
            <a:ln w="12700" cap="rnd">
              <a:solidFill>
                <a:schemeClr val="tx1"/>
              </a:solidFill>
              <a:prstDash val="lgDashDotDot"/>
              <a:round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E$56:$E$59</c:f>
              <c:numCache>
                <c:formatCode>0.000</c:formatCode>
                <c:ptCount val="4"/>
                <c:pt idx="0">
                  <c:v>2.7252120799441386E-4</c:v>
                </c:pt>
                <c:pt idx="1">
                  <c:v>4.1846651237682489E-3</c:v>
                </c:pt>
                <c:pt idx="2">
                  <c:v>6.1616040783809486E-3</c:v>
                </c:pt>
                <c:pt idx="3">
                  <c:v>6.6422852997043572E-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C635-2144-9361-5CC54751EE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2032112"/>
        <c:axId val="181721936"/>
      </c:scatterChart>
      <c:scatterChart>
        <c:scatterStyle val="lineMarker"/>
        <c:varyColors val="0"/>
        <c:ser>
          <c:idx val="4"/>
          <c:order val="4"/>
          <c:tx>
            <c:strRef>
              <c:f>Data!$F$5</c:f>
              <c:strCache>
                <c:ptCount val="1"/>
                <c:pt idx="0">
                  <c:v>Tmax/ Cmax (secondary axis)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x"/>
            <c:size val="6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dLbls>
            <c:dLbl>
              <c:idx val="0"/>
              <c:layout>
                <c:manualLayout>
                  <c:x val="-5.0030576015917776E-17"/>
                  <c:y val="-4.183380975564463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older fe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4-C635-2144-9361-5CC54751EE96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/>
                      <a:t>older 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5-C635-2144-9361-5CC54751EE96}"/>
                </c:ext>
              </c:extLst>
            </c:dLbl>
            <c:dLbl>
              <c:idx val="2"/>
              <c:layout>
                <c:manualLayout>
                  <c:x val="1.0915888139651119E-2"/>
                  <c:y val="8.3667619511288479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younger fe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6-C635-2144-9361-5CC54751EE96}"/>
                </c:ext>
              </c:extLst>
            </c:dLbl>
            <c:dLbl>
              <c:idx val="3"/>
              <c:layout>
                <c:manualLayout>
                  <c:x val="-5.7308412733168633E-2"/>
                  <c:y val="-4.1833809755644435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younger 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7-C635-2144-9361-5CC54751EE96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Data!$G$56:$G$59</c:f>
              <c:numCache>
                <c:formatCode>0.00</c:formatCode>
                <c:ptCount val="4"/>
                <c:pt idx="0">
                  <c:v>6.590909090909097</c:v>
                </c:pt>
                <c:pt idx="1">
                  <c:v>6.6847826086956514</c:v>
                </c:pt>
                <c:pt idx="2">
                  <c:v>2.7499999999999973</c:v>
                </c:pt>
                <c:pt idx="3">
                  <c:v>6.370967741935484</c:v>
                </c:pt>
              </c:numCache>
            </c:numRef>
          </c:xVal>
          <c:yVal>
            <c:numRef>
              <c:f>Data!$F$56:$F$59</c:f>
              <c:numCache>
                <c:formatCode>0.00</c:formatCode>
                <c:ptCount val="4"/>
                <c:pt idx="0">
                  <c:v>0.6475312073889663</c:v>
                </c:pt>
                <c:pt idx="1">
                  <c:v>0.21036823386934256</c:v>
                </c:pt>
                <c:pt idx="2">
                  <c:v>0.52232410983205679</c:v>
                </c:pt>
                <c:pt idx="3">
                  <c:v>1.7217698510765933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C635-2144-9361-5CC54751EE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3810576"/>
        <c:axId val="207755872"/>
      </c:scatterChart>
      <c:valAx>
        <c:axId val="182032112"/>
        <c:scaling>
          <c:orientation val="minMax"/>
          <c:max val="2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Time (hours)</a:t>
                </a:r>
              </a:p>
            </c:rich>
          </c:tx>
          <c:layout>
            <c:manualLayout>
              <c:xMode val="edge"/>
              <c:yMode val="edge"/>
              <c:x val="0.46761979600830411"/>
              <c:y val="0.94242507153449318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1721936"/>
        <c:crosses val="autoZero"/>
        <c:crossBetween val="midCat"/>
        <c:majorUnit val="4"/>
      </c:valAx>
      <c:valAx>
        <c:axId val="1817219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>
                    <a:solidFill>
                      <a:schemeClr val="tx1"/>
                    </a:solidFill>
                  </a:rPr>
                  <a:t>Cumulative</a:t>
                </a:r>
                <a:r>
                  <a:rPr lang="en-GB" baseline="0">
                    <a:solidFill>
                      <a:schemeClr val="tx1"/>
                    </a:solidFill>
                  </a:rPr>
                  <a:t> c</a:t>
                </a:r>
                <a:r>
                  <a:rPr lang="en-GB">
                    <a:solidFill>
                      <a:schemeClr val="tx1"/>
                    </a:solidFill>
                  </a:rPr>
                  <a:t>oncentration</a:t>
                </a:r>
              </a:p>
            </c:rich>
          </c:tx>
          <c:layout>
            <c:manualLayout>
              <c:xMode val="edge"/>
              <c:yMode val="edge"/>
              <c:x val="1.5616992582602829E-2"/>
              <c:y val="0.3611130140562668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0.0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2032112"/>
        <c:crosses val="autoZero"/>
        <c:crossBetween val="midCat"/>
      </c:valAx>
      <c:valAx>
        <c:axId val="207755872"/>
        <c:scaling>
          <c:orientation val="minMax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Maximum concentration</a:t>
                </a:r>
              </a:p>
            </c:rich>
          </c:tx>
          <c:layout>
            <c:manualLayout>
              <c:xMode val="edge"/>
              <c:yMode val="edge"/>
              <c:x val="0.96723353299592907"/>
              <c:y val="0.3558178395937793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  <a:prstDash val="sysDot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810576"/>
        <c:crosses val="max"/>
        <c:crossBetween val="midCat"/>
      </c:valAx>
      <c:valAx>
        <c:axId val="193810576"/>
        <c:scaling>
          <c:orientation val="minMax"/>
          <c:max val="24"/>
          <c:min val="0"/>
        </c:scaling>
        <c:delete val="1"/>
        <c:axPos val="t"/>
        <c:numFmt formatCode="0.00" sourceLinked="1"/>
        <c:majorTickMark val="out"/>
        <c:minorTickMark val="none"/>
        <c:tickLblPos val="nextTo"/>
        <c:crossAx val="207755872"/>
        <c:crosses val="max"/>
        <c:crossBetween val="midCat"/>
        <c:majorUnit val="4"/>
      </c:valAx>
    </c:plotArea>
    <c:legend>
      <c:legendPos val="l"/>
      <c:layout>
        <c:manualLayout>
          <c:xMode val="edge"/>
          <c:yMode val="edge"/>
          <c:x val="0.6565552164515327"/>
          <c:y val="2.5270915093177401E-2"/>
          <c:w val="0.24774521371611433"/>
          <c:h val="0.1267740664637123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b="1" dirty="0"/>
              <a:t>3-hydroxybenzoic </a:t>
            </a:r>
            <a:r>
              <a:rPr lang="en-GB" b="1" dirty="0" smtClean="0"/>
              <a:t>acid-4-</a:t>
            </a:r>
            <a:r>
              <a:rPr lang="en-GB" b="1" i="1" dirty="0" smtClean="0"/>
              <a:t>O</a:t>
            </a:r>
            <a:r>
              <a:rPr lang="en-GB" b="1" dirty="0" smtClean="0"/>
              <a:t>-glucuronide</a:t>
            </a:r>
            <a:endParaRPr lang="en-GB" b="1" dirty="0"/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0409953867867502"/>
          <c:y val="5.1549654467208252E-2"/>
          <c:w val="0.8137110249163827"/>
          <c:h val="0.83488085096061249"/>
        </c:manualLayout>
      </c:layout>
      <c:scatterChart>
        <c:scatterStyle val="smoothMarker"/>
        <c:varyColors val="0"/>
        <c:ser>
          <c:idx val="1"/>
          <c:order val="0"/>
          <c:tx>
            <c:strRef>
              <c:f>Data!$B$5</c:f>
              <c:strCache>
                <c:ptCount val="1"/>
                <c:pt idx="0">
                  <c:v>Older females</c:v>
                </c:pt>
              </c:strCache>
            </c:strRef>
          </c:tx>
          <c:spPr>
            <a:ln w="2222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squar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B$63:$B$66</c:f>
              <c:numCache>
                <c:formatCode>General</c:formatCode>
                <c:ptCount val="4"/>
                <c:pt idx="0">
                  <c:v>6.1137903981321913E-2</c:v>
                </c:pt>
                <c:pt idx="1">
                  <c:v>1.0078365310288366</c:v>
                </c:pt>
                <c:pt idx="2">
                  <c:v>1.5180754799675544</c:v>
                </c:pt>
                <c:pt idx="3">
                  <c:v>1.626315169171738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BB8F-CF4E-AA44-DA9DCDDCA7E3}"/>
            </c:ext>
          </c:extLst>
        </c:ser>
        <c:ser>
          <c:idx val="0"/>
          <c:order val="1"/>
          <c:tx>
            <c:strRef>
              <c:f>Data!$C$5</c:f>
              <c:strCache>
                <c:ptCount val="1"/>
                <c:pt idx="0">
                  <c:v>Older males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C$63:$C$66</c:f>
              <c:numCache>
                <c:formatCode>General</c:formatCode>
                <c:ptCount val="4"/>
                <c:pt idx="0">
                  <c:v>6.6231685813354368E-2</c:v>
                </c:pt>
                <c:pt idx="1">
                  <c:v>0.61271778689479106</c:v>
                </c:pt>
                <c:pt idx="2">
                  <c:v>1.3443401902262364</c:v>
                </c:pt>
                <c:pt idx="3">
                  <c:v>1.575451761820343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BB8F-CF4E-AA44-DA9DCDDCA7E3}"/>
            </c:ext>
          </c:extLst>
        </c:ser>
        <c:ser>
          <c:idx val="2"/>
          <c:order val="2"/>
          <c:tx>
            <c:strRef>
              <c:f>Data!$D$5</c:f>
              <c:strCache>
                <c:ptCount val="1"/>
                <c:pt idx="0">
                  <c:v>Younger females</c:v>
                </c:pt>
              </c:strCache>
            </c:strRef>
          </c:tx>
          <c:spPr>
            <a:ln w="2222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triang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D$63:$D$66</c:f>
              <c:numCache>
                <c:formatCode>General</c:formatCode>
                <c:ptCount val="4"/>
                <c:pt idx="0">
                  <c:v>0.1082368304407637</c:v>
                </c:pt>
                <c:pt idx="1">
                  <c:v>0.96694608746314115</c:v>
                </c:pt>
                <c:pt idx="2">
                  <c:v>1.4407055300763967</c:v>
                </c:pt>
                <c:pt idx="3">
                  <c:v>1.548017691584521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BB8F-CF4E-AA44-DA9DCDDCA7E3}"/>
            </c:ext>
          </c:extLst>
        </c:ser>
        <c:ser>
          <c:idx val="3"/>
          <c:order val="3"/>
          <c:tx>
            <c:strRef>
              <c:f>Data!$E$5</c:f>
              <c:strCache>
                <c:ptCount val="1"/>
                <c:pt idx="0">
                  <c:v>Younger males</c:v>
                </c:pt>
              </c:strCache>
            </c:strRef>
          </c:tx>
          <c:spPr>
            <a:ln w="12700" cap="rnd">
              <a:solidFill>
                <a:schemeClr val="tx1"/>
              </a:solidFill>
              <a:prstDash val="lgDashDotDot"/>
              <a:round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E$63:$E$66</c:f>
              <c:numCache>
                <c:formatCode>General</c:formatCode>
                <c:ptCount val="4"/>
                <c:pt idx="0">
                  <c:v>7.600004326160828E-2</c:v>
                </c:pt>
                <c:pt idx="1">
                  <c:v>0.54969451535635583</c:v>
                </c:pt>
                <c:pt idx="2">
                  <c:v>0.84993598438723483</c:v>
                </c:pt>
                <c:pt idx="3">
                  <c:v>0.9074282389414262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BB8F-CF4E-AA44-DA9DCDDCA7E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2032112"/>
        <c:axId val="181721936"/>
      </c:scatterChart>
      <c:scatterChart>
        <c:scatterStyle val="lineMarker"/>
        <c:varyColors val="0"/>
        <c:ser>
          <c:idx val="4"/>
          <c:order val="4"/>
          <c:tx>
            <c:strRef>
              <c:f>Data!$F$5</c:f>
              <c:strCache>
                <c:ptCount val="1"/>
                <c:pt idx="0">
                  <c:v>Tmax/ Cmax (secondary axis)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x"/>
            <c:size val="6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dLbls>
            <c:dLbl>
              <c:idx val="0"/>
              <c:layout>
                <c:manualLayout>
                  <c:x val="-1.3644860174564961E-3"/>
                  <c:y val="2.7191976341168884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older fe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4-BB8F-CF4E-AA44-DA9DCDDCA7E3}"/>
                </c:ext>
              </c:extLst>
            </c:dLbl>
            <c:dLbl>
              <c:idx val="1"/>
              <c:layout>
                <c:manualLayout>
                  <c:x val="4.0934580523691883E-3"/>
                  <c:y val="4.1833809755644439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older 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5-BB8F-CF4E-AA44-DA9DCDDCA7E3}"/>
                </c:ext>
              </c:extLst>
            </c:dLbl>
            <c:dLbl>
              <c:idx val="2"/>
              <c:layout>
                <c:manualLayout>
                  <c:x val="-0.15828037802494196"/>
                  <c:y val="-2.0916904877822219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younger fe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6-BB8F-CF4E-AA44-DA9DCDDCA7E3}"/>
                </c:ext>
              </c:extLst>
            </c:dLbl>
            <c:dLbl>
              <c:idx val="3"/>
              <c:layout>
                <c:manualLayout>
                  <c:x val="4.0934580523691883E-3"/>
                  <c:y val="-4.1833809755645202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younger 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7-BB8F-CF4E-AA44-DA9DCDDCA7E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Data!$G$63:$G$66</c:f>
              <c:numCache>
                <c:formatCode>0.00</c:formatCode>
                <c:ptCount val="4"/>
                <c:pt idx="0">
                  <c:v>9.5681818181818219</c:v>
                </c:pt>
                <c:pt idx="1">
                  <c:v>11.456521739130434</c:v>
                </c:pt>
                <c:pt idx="2">
                  <c:v>6.2738095238095237</c:v>
                </c:pt>
                <c:pt idx="3">
                  <c:v>4.9354838709677402</c:v>
                </c:pt>
              </c:numCache>
            </c:numRef>
          </c:xVal>
          <c:yVal>
            <c:numRef>
              <c:f>Data!$F$63:$F$66</c:f>
              <c:numCache>
                <c:formatCode>0.00</c:formatCode>
                <c:ptCount val="4"/>
                <c:pt idx="0">
                  <c:v>4.7042181146521658E-2</c:v>
                </c:pt>
                <c:pt idx="1">
                  <c:v>5.6267295929896835E-2</c:v>
                </c:pt>
                <c:pt idx="2">
                  <c:v>4.7967514733034289E-2</c:v>
                </c:pt>
                <c:pt idx="3">
                  <c:v>3.2897966748644251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BB8F-CF4E-AA44-DA9DCDDCA7E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3810576"/>
        <c:axId val="207755872"/>
      </c:scatterChart>
      <c:valAx>
        <c:axId val="182032112"/>
        <c:scaling>
          <c:orientation val="minMax"/>
          <c:max val="2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Time (hours)</a:t>
                </a:r>
              </a:p>
            </c:rich>
          </c:tx>
          <c:layout>
            <c:manualLayout>
              <c:xMode val="edge"/>
              <c:yMode val="edge"/>
              <c:x val="0.46761979600830411"/>
              <c:y val="0.94242507153449318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1721936"/>
        <c:crosses val="autoZero"/>
        <c:crossBetween val="midCat"/>
        <c:majorUnit val="4"/>
      </c:valAx>
      <c:valAx>
        <c:axId val="1817219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>
                    <a:solidFill>
                      <a:schemeClr val="tx1"/>
                    </a:solidFill>
                  </a:rPr>
                  <a:t>Cumulative</a:t>
                </a:r>
                <a:r>
                  <a:rPr lang="en-GB" baseline="0">
                    <a:solidFill>
                      <a:schemeClr val="tx1"/>
                    </a:solidFill>
                  </a:rPr>
                  <a:t> c</a:t>
                </a:r>
                <a:r>
                  <a:rPr lang="en-GB">
                    <a:solidFill>
                      <a:schemeClr val="tx1"/>
                    </a:solidFill>
                  </a:rPr>
                  <a:t>oncentration</a:t>
                </a:r>
              </a:p>
            </c:rich>
          </c:tx>
          <c:layout>
            <c:manualLayout>
              <c:xMode val="edge"/>
              <c:yMode val="edge"/>
              <c:x val="1.5616992582602829E-2"/>
              <c:y val="0.3611130140562668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2032112"/>
        <c:crosses val="autoZero"/>
        <c:crossBetween val="midCat"/>
      </c:valAx>
      <c:valAx>
        <c:axId val="207755872"/>
        <c:scaling>
          <c:orientation val="minMax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Maximum concentration</a:t>
                </a:r>
              </a:p>
            </c:rich>
          </c:tx>
          <c:layout>
            <c:manualLayout>
              <c:xMode val="edge"/>
              <c:yMode val="edge"/>
              <c:x val="0.96723353299592907"/>
              <c:y val="0.3558178395937793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.0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  <a:prstDash val="sysDot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810576"/>
        <c:crosses val="max"/>
        <c:crossBetween val="midCat"/>
      </c:valAx>
      <c:valAx>
        <c:axId val="193810576"/>
        <c:scaling>
          <c:orientation val="minMax"/>
          <c:max val="24"/>
          <c:min val="0"/>
        </c:scaling>
        <c:delete val="1"/>
        <c:axPos val="t"/>
        <c:numFmt formatCode="0.00" sourceLinked="1"/>
        <c:majorTickMark val="out"/>
        <c:minorTickMark val="none"/>
        <c:tickLblPos val="nextTo"/>
        <c:crossAx val="207755872"/>
        <c:crosses val="max"/>
        <c:crossBetween val="midCat"/>
        <c:majorUnit val="4"/>
      </c:valAx>
    </c:plotArea>
    <c:legend>
      <c:legendPos val="l"/>
      <c:layout>
        <c:manualLayout>
          <c:xMode val="edge"/>
          <c:yMode val="edge"/>
          <c:x val="0.11485426752134344"/>
          <c:y val="3.991274850765289E-2"/>
          <c:w val="0.24774521371611433"/>
          <c:h val="0.1267740664637123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b="1"/>
              <a:t>3-methoxybenzoic acid-4-sulfate</a:t>
            </a: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9.5912623042795228E-2"/>
          <c:y val="5.3641320209155879E-2"/>
          <c:w val="0.8137110249163827"/>
          <c:h val="0.83488085096061249"/>
        </c:manualLayout>
      </c:layout>
      <c:scatterChart>
        <c:scatterStyle val="smoothMarker"/>
        <c:varyColors val="0"/>
        <c:ser>
          <c:idx val="1"/>
          <c:order val="0"/>
          <c:tx>
            <c:strRef>
              <c:f>Data!$B$5</c:f>
              <c:strCache>
                <c:ptCount val="1"/>
                <c:pt idx="0">
                  <c:v>Older females</c:v>
                </c:pt>
              </c:strCache>
            </c:strRef>
          </c:tx>
          <c:spPr>
            <a:ln w="2222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squar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B$69:$B$72</c:f>
              <c:numCache>
                <c:formatCode>0.000</c:formatCode>
                <c:ptCount val="4"/>
                <c:pt idx="0">
                  <c:v>3.2235850224383043E-2</c:v>
                </c:pt>
                <c:pt idx="1">
                  <c:v>0.29245844857577313</c:v>
                </c:pt>
                <c:pt idx="2">
                  <c:v>0.53181398206899044</c:v>
                </c:pt>
                <c:pt idx="3">
                  <c:v>0.615961704170385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9B1A-0F49-A1CF-4E939DB795E9}"/>
            </c:ext>
          </c:extLst>
        </c:ser>
        <c:ser>
          <c:idx val="0"/>
          <c:order val="1"/>
          <c:tx>
            <c:strRef>
              <c:f>Data!$C$5</c:f>
              <c:strCache>
                <c:ptCount val="1"/>
                <c:pt idx="0">
                  <c:v>Older males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C$69:$C$72</c:f>
              <c:numCache>
                <c:formatCode>0.000</c:formatCode>
                <c:ptCount val="4"/>
                <c:pt idx="0">
                  <c:v>5.6493979220709319E-2</c:v>
                </c:pt>
                <c:pt idx="1">
                  <c:v>0.37116763294132882</c:v>
                </c:pt>
                <c:pt idx="2">
                  <c:v>0.72058468051770341</c:v>
                </c:pt>
                <c:pt idx="3">
                  <c:v>0.8719025484245813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9B1A-0F49-A1CF-4E939DB795E9}"/>
            </c:ext>
          </c:extLst>
        </c:ser>
        <c:ser>
          <c:idx val="2"/>
          <c:order val="2"/>
          <c:tx>
            <c:strRef>
              <c:f>Data!$D$5</c:f>
              <c:strCache>
                <c:ptCount val="1"/>
                <c:pt idx="0">
                  <c:v>Younger females</c:v>
                </c:pt>
              </c:strCache>
            </c:strRef>
          </c:tx>
          <c:spPr>
            <a:ln w="2222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triang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D$69:$D$72</c:f>
              <c:numCache>
                <c:formatCode>0.000</c:formatCode>
                <c:ptCount val="4"/>
                <c:pt idx="0">
                  <c:v>4.0674549507367111E-2</c:v>
                </c:pt>
                <c:pt idx="1">
                  <c:v>0.24911617032151417</c:v>
                </c:pt>
                <c:pt idx="2">
                  <c:v>0.4587166458561191</c:v>
                </c:pt>
                <c:pt idx="3">
                  <c:v>0.5245620956221053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9B1A-0F49-A1CF-4E939DB795E9}"/>
            </c:ext>
          </c:extLst>
        </c:ser>
        <c:ser>
          <c:idx val="3"/>
          <c:order val="3"/>
          <c:tx>
            <c:strRef>
              <c:f>Data!$E$5</c:f>
              <c:strCache>
                <c:ptCount val="1"/>
                <c:pt idx="0">
                  <c:v>Younger males</c:v>
                </c:pt>
              </c:strCache>
            </c:strRef>
          </c:tx>
          <c:spPr>
            <a:ln w="12700" cap="rnd">
              <a:solidFill>
                <a:schemeClr val="tx1"/>
              </a:solidFill>
              <a:prstDash val="lgDashDotDot"/>
              <a:round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ata!$A$6:$A$9</c:f>
              <c:numCache>
                <c:formatCode>General</c:formatCode>
                <c:ptCount val="4"/>
                <c:pt idx="0">
                  <c:v>0</c:v>
                </c:pt>
                <c:pt idx="1">
                  <c:v>3.5</c:v>
                </c:pt>
                <c:pt idx="2">
                  <c:v>7</c:v>
                </c:pt>
                <c:pt idx="3">
                  <c:v>24</c:v>
                </c:pt>
              </c:numCache>
            </c:numRef>
          </c:xVal>
          <c:yVal>
            <c:numRef>
              <c:f>Data!$E$69:$E$72</c:f>
              <c:numCache>
                <c:formatCode>0.000</c:formatCode>
                <c:ptCount val="4"/>
                <c:pt idx="0">
                  <c:v>0.12739028004434741</c:v>
                </c:pt>
                <c:pt idx="1">
                  <c:v>0.44801469077364475</c:v>
                </c:pt>
                <c:pt idx="2">
                  <c:v>0.74264141658892835</c:v>
                </c:pt>
                <c:pt idx="3">
                  <c:v>0.9004137580719306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9B1A-0F49-A1CF-4E939DB795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2032112"/>
        <c:axId val="181721936"/>
      </c:scatterChart>
      <c:scatterChart>
        <c:scatterStyle val="lineMarker"/>
        <c:varyColors val="0"/>
        <c:ser>
          <c:idx val="4"/>
          <c:order val="4"/>
          <c:tx>
            <c:strRef>
              <c:f>Data!$F$5</c:f>
              <c:strCache>
                <c:ptCount val="1"/>
                <c:pt idx="0">
                  <c:v>Tmax/ Cmax (secondary axis)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x"/>
            <c:size val="6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dLbls>
            <c:dLbl>
              <c:idx val="0"/>
              <c:layout>
                <c:manualLayout>
                  <c:x val="1.364486017456296E-3"/>
                  <c:y val="-2.0916904877822983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older fe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4-9B1A-0F49-A1CF-4E939DB795E9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/>
                      <a:t>older 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5-9B1A-0F49-A1CF-4E939DB795E9}"/>
                </c:ext>
              </c:extLst>
            </c:dLbl>
            <c:dLbl>
              <c:idx val="2"/>
              <c:layout>
                <c:manualLayout>
                  <c:x val="2.7289720349127924E-3"/>
                  <c:y val="7.6694431904726175E-17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younger fe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6-9B1A-0F49-A1CF-4E939DB795E9}"/>
                </c:ext>
              </c:extLst>
            </c:dLbl>
            <c:dLbl>
              <c:idx val="3"/>
              <c:layout>
                <c:manualLayout>
                  <c:x val="4.0934580523691883E-3"/>
                  <c:y val="-2.0916904877822219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younger males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7-9B1A-0F49-A1CF-4E939DB795E9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xVal>
            <c:numRef>
              <c:f>Data!$G$69:$G$72</c:f>
              <c:numCache>
                <c:formatCode>0.00</c:formatCode>
                <c:ptCount val="4"/>
                <c:pt idx="0">
                  <c:v>15.056818181818183</c:v>
                </c:pt>
                <c:pt idx="1">
                  <c:v>13.880434782608695</c:v>
                </c:pt>
                <c:pt idx="2">
                  <c:v>14.226190476190476</c:v>
                </c:pt>
                <c:pt idx="3">
                  <c:v>11.403225806451612</c:v>
                </c:pt>
              </c:numCache>
            </c:numRef>
          </c:xVal>
          <c:yVal>
            <c:numRef>
              <c:f>Data!$F$69:$F$72</c:f>
              <c:numCache>
                <c:formatCode>0.00</c:formatCode>
                <c:ptCount val="4"/>
                <c:pt idx="0">
                  <c:v>1.8109106638214807</c:v>
                </c:pt>
                <c:pt idx="1">
                  <c:v>2.6711671971108597</c:v>
                </c:pt>
                <c:pt idx="2">
                  <c:v>1.448065330939633</c:v>
                </c:pt>
                <c:pt idx="3">
                  <c:v>4.428221786695141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9B1A-0F49-A1CF-4E939DB795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3810576"/>
        <c:axId val="207755872"/>
      </c:scatterChart>
      <c:valAx>
        <c:axId val="182032112"/>
        <c:scaling>
          <c:orientation val="minMax"/>
          <c:max val="2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Time (hours)</a:t>
                </a:r>
              </a:p>
            </c:rich>
          </c:tx>
          <c:layout>
            <c:manualLayout>
              <c:xMode val="edge"/>
              <c:yMode val="edge"/>
              <c:x val="0.46761979600830411"/>
              <c:y val="0.94242507153449318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1721936"/>
        <c:crosses val="autoZero"/>
        <c:crossBetween val="midCat"/>
        <c:majorUnit val="4"/>
      </c:valAx>
      <c:valAx>
        <c:axId val="1817219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>
                    <a:solidFill>
                      <a:schemeClr val="tx1"/>
                    </a:solidFill>
                  </a:rPr>
                  <a:t>Cumulative</a:t>
                </a:r>
                <a:r>
                  <a:rPr lang="en-GB" baseline="0">
                    <a:solidFill>
                      <a:schemeClr val="tx1"/>
                    </a:solidFill>
                  </a:rPr>
                  <a:t> c</a:t>
                </a:r>
                <a:r>
                  <a:rPr lang="en-GB">
                    <a:solidFill>
                      <a:schemeClr val="tx1"/>
                    </a:solidFill>
                  </a:rPr>
                  <a:t>oncentration</a:t>
                </a:r>
              </a:p>
            </c:rich>
          </c:tx>
          <c:layout>
            <c:manualLayout>
              <c:xMode val="edge"/>
              <c:yMode val="edge"/>
              <c:x val="1.5616992582602829E-2"/>
              <c:y val="0.3611130140562668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2032112"/>
        <c:crosses val="autoZero"/>
        <c:crossBetween val="midCat"/>
      </c:valAx>
      <c:valAx>
        <c:axId val="207755872"/>
        <c:scaling>
          <c:orientation val="minMax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Maximum concentration</a:t>
                </a:r>
              </a:p>
            </c:rich>
          </c:tx>
          <c:layout>
            <c:manualLayout>
              <c:xMode val="edge"/>
              <c:yMode val="edge"/>
              <c:x val="0.96723353299592907"/>
              <c:y val="0.3558178395937793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  <a:prstDash val="sysDot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810576"/>
        <c:crosses val="max"/>
        <c:crossBetween val="midCat"/>
      </c:valAx>
      <c:valAx>
        <c:axId val="193810576"/>
        <c:scaling>
          <c:orientation val="minMax"/>
          <c:max val="24"/>
          <c:min val="0"/>
        </c:scaling>
        <c:delete val="1"/>
        <c:axPos val="t"/>
        <c:numFmt formatCode="0.00" sourceLinked="1"/>
        <c:majorTickMark val="out"/>
        <c:minorTickMark val="none"/>
        <c:tickLblPos val="nextTo"/>
        <c:crossAx val="207755872"/>
        <c:crosses val="max"/>
        <c:crossBetween val="midCat"/>
        <c:majorUnit val="4"/>
      </c:valAx>
    </c:plotArea>
    <c:legend>
      <c:legendPos val="l"/>
      <c:layout>
        <c:manualLayout>
          <c:xMode val="edge"/>
          <c:yMode val="edge"/>
          <c:x val="0.10530286539914867"/>
          <c:y val="5.2462891434346286E-2"/>
          <c:w val="0.24774521371611433"/>
          <c:h val="0.1267740664637123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C2ABF1-230A-754B-B47E-F5B6BE785E7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58D68F9-4A5B-6E40-A05E-381B88543F1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4419CF-7FEE-914E-872B-384BDAC8E1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70CA3-B657-BE46-8E86-90E8F410051E}" type="datetimeFigureOut">
              <a:rPr lang="en-US" smtClean="0"/>
              <a:t>4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B9E3FF-AD29-8F48-B4F1-4D8FBF9A90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CCE588-77FE-1B4F-8DCB-BA79E80D31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81FE2-E697-3141-9F53-8A8183313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30446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49F11C-3A3C-FC4A-A1F5-C5AC51F6BE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CBEAAF2-6119-4C47-8929-46BCE782DC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5B73F9-0E31-5640-8107-C2BBFCDA0A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70CA3-B657-BE46-8E86-90E8F410051E}" type="datetimeFigureOut">
              <a:rPr lang="en-US" smtClean="0"/>
              <a:t>4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20BD1A-41EE-244A-BF40-C2286F229B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283390-DC16-A04C-AE0A-E59E3CA670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81FE2-E697-3141-9F53-8A8183313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90598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5361D1B-CBFD-D040-A871-1DD2F7827FA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ECD093A-F7CE-0F4C-972C-99AF453285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084DC8-765B-884A-8B1E-54F48DD9F1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70CA3-B657-BE46-8E86-90E8F410051E}" type="datetimeFigureOut">
              <a:rPr lang="en-US" smtClean="0"/>
              <a:t>4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21C3BB-79B7-F141-BB9A-E4A86D970B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0091B2-7ED8-A14A-915E-0AB304F510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81FE2-E697-3141-9F53-8A8183313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66120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FE7828-9275-244F-9992-74627CAF1D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916AA8-A62E-7E43-8E88-2A78649470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31633B-E617-3342-8ADC-FB922F5098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70CA3-B657-BE46-8E86-90E8F410051E}" type="datetimeFigureOut">
              <a:rPr lang="en-US" smtClean="0"/>
              <a:t>4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8E9232-5FF3-2C42-8C4F-5191AC943A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D0482E-A690-9249-B4ED-AB29C6D35A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81FE2-E697-3141-9F53-8A8183313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75461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E3A4AE-E9CC-2640-917D-475334BDA5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3FBC018-AD5D-EC46-BE02-3C8CC6438E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C5D95D-D4C9-B04F-8ACA-470D7FDC9C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70CA3-B657-BE46-8E86-90E8F410051E}" type="datetimeFigureOut">
              <a:rPr lang="en-US" smtClean="0"/>
              <a:t>4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0EA999-916B-7C4B-9605-F4F2253AFC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873E1A-A92D-8248-A9F8-8C6032FBB6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81FE2-E697-3141-9F53-8A8183313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3157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8DBC71-E9A4-A84A-8F04-4D1A3D2BF3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827B1F-D3F3-F048-8593-CBD7BA79294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CA952D7-5081-9442-BEC9-C243EA74AA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6EEB3F-5805-D941-A064-358EFD7446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70CA3-B657-BE46-8E86-90E8F410051E}" type="datetimeFigureOut">
              <a:rPr lang="en-US" smtClean="0"/>
              <a:t>4/2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A5681E-BF73-8448-AB37-3A54261C9C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21BD907-7519-6C48-AB3E-DE53CCC64D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81FE2-E697-3141-9F53-8A8183313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0567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ADA3F9-2768-1B41-AC74-BBD6FBA9D2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8154582-9212-2747-A3C0-18A1B553EA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3036E4-7620-C848-A8F7-D7CFA184CB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35119E7-E4CD-F448-911E-F0B9B45459B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57D1C5E-50A6-E243-8A83-5A97010B9C1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FE0C47F-3593-6A48-862F-B5BEA8EDB4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70CA3-B657-BE46-8E86-90E8F410051E}" type="datetimeFigureOut">
              <a:rPr lang="en-US" smtClean="0"/>
              <a:t>4/23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CA7045A-E27A-3E42-8F46-BE7A494C53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0FF1E73-14C2-144B-A601-5DFA71823B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81FE2-E697-3141-9F53-8A8183313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7516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45CAA9-E146-3645-BEB9-4C82FB34EB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66134B6-17EC-CA40-B490-178498CB59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70CA3-B657-BE46-8E86-90E8F410051E}" type="datetimeFigureOut">
              <a:rPr lang="en-US" smtClean="0"/>
              <a:t>4/23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EF8CB74-DD24-CB4A-B00A-9DCBAC1CF4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7D06973-5FB0-A74B-9018-42AEEFB2A7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81FE2-E697-3141-9F53-8A8183313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81937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9CA0C21-92FC-FC41-94E7-9C16375041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70CA3-B657-BE46-8E86-90E8F410051E}" type="datetimeFigureOut">
              <a:rPr lang="en-US" smtClean="0"/>
              <a:t>4/23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5ED4DD4-65E0-5242-82D2-E947D9C37E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0926C9D-F0C4-4B4E-96A7-F3EC665271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81FE2-E697-3141-9F53-8A8183313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70117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BA9D43-2385-424C-9E1F-5F97BD4EAB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62F874-7221-A940-A9E3-5E67E99C1F7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B998428-894C-C247-9D40-C1FE11BCF7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D0A6DDF-7C29-964C-8028-3FAA3CE2AC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70CA3-B657-BE46-8E86-90E8F410051E}" type="datetimeFigureOut">
              <a:rPr lang="en-US" smtClean="0"/>
              <a:t>4/2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E3E766-BEDF-F34F-910A-3770DFC4B9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32F845A-8603-0841-9826-6CB4EA9563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81FE2-E697-3141-9F53-8A8183313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7345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9BFBFB-2426-CE4D-9E00-8678DC2166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C84CC63-F5D7-DC43-A019-7DF026C0FE9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EBAEF98-7C4A-FB48-A84C-5E076569AA7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D1AC48-7F92-D447-8477-2356EED6CC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70CA3-B657-BE46-8E86-90E8F410051E}" type="datetimeFigureOut">
              <a:rPr lang="en-US" smtClean="0"/>
              <a:t>4/2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53C3B79-8049-7C46-AF1D-E761CA8DFB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511017B-7782-C34F-B403-EF24B214DA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81FE2-E697-3141-9F53-8A8183313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10013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3A35EE6-8FD8-A64D-8EED-FB1B83351B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92F47F-2809-E648-AF34-87A6BA1F1A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F01EE8-1A71-4C43-98A1-0E4EF5F80FB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C70CA3-B657-BE46-8E86-90E8F410051E}" type="datetimeFigureOut">
              <a:rPr lang="en-US" smtClean="0"/>
              <a:t>4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F6ADF4-D4BC-3247-9529-2E52FF9D57A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440B43-48AB-C240-B290-991A7313FDC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A81FE2-E697-3141-9F53-8A8183313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7307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0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1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2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3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35021CF-C85B-0764-5678-5156B8660AE6}"/>
              </a:ext>
            </a:extLst>
          </p:cNvPr>
          <p:cNvSpPr txBox="1"/>
          <p:nvPr/>
        </p:nvSpPr>
        <p:spPr>
          <a:xfrm>
            <a:off x="290059" y="290036"/>
            <a:ext cx="11721927" cy="409023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pPr marL="0" marR="0">
              <a:lnSpc>
                <a:spcPct val="200000"/>
              </a:lnSpc>
            </a:pP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Effect of age and sex on the urinary elimination of a single dose of mixed flavonoids: results from a single-arm  intervention in healthy UK adults</a:t>
            </a: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olin D Kay et al., ACNC 2025</a:t>
            </a:r>
            <a:endParaRPr lang="en-US" sz="12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1820D3A-ED3B-DEE5-D10B-3FCCE5804FA3}"/>
              </a:ext>
            </a:extLst>
          </p:cNvPr>
          <p:cNvSpPr txBox="1"/>
          <p:nvPr/>
        </p:nvSpPr>
        <p:spPr>
          <a:xfrm>
            <a:off x="377072" y="1027522"/>
            <a:ext cx="10837519" cy="55399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>
              <a:lnSpc>
                <a:spcPct val="200000"/>
              </a:lnSpc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L FIGURES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200000"/>
              </a:lnSpc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l Figure 1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Naringenin elimination kinetics for cumulative concentration over time (including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max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max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by age and sex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200000"/>
              </a:lnSpc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l Figure 2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Naringenin-7-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O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glucuronide elimination kinetics for cumulative concentration over time (including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max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max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by age and sex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200000"/>
              </a:lnSpc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l Figure 3. </a:t>
            </a:r>
            <a:r>
              <a:rPr lang="en-US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-)-</a:t>
            </a:r>
            <a:r>
              <a:rPr lang="en-US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Epicatechin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elimination kinetics for cumulative concentration over time (including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max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max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by age and sex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200000"/>
              </a:lnSpc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l Figure 4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5-(Hydroxyphenyl)-gamma-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valerolactone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elimination kinetics for cumulative concentration over time (including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max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max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by age and sex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200000"/>
              </a:lnSpc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l Figure 5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Hesperetin-3'-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O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glucuronide elimination kinetics for cumulative concentration over time (including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max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max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by age and sex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200000"/>
              </a:lnSpc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l Figure 6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Hesperetin-7'-sulfate elimination kinetics for cumulative concentration over time (including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max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max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by age and sex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200000"/>
              </a:lnSpc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l Figure 7. 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yanidin-3-</a:t>
            </a:r>
            <a:r>
              <a:rPr lang="en-US" sz="1200" i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O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glucoside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elimination kinetics for cumulative concentration over time (including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max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max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by age and sex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200000"/>
              </a:lnSpc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l Figure 8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3-hydroxybenzoic acid-4-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O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glucuronide elimination kinetics for cumulative concentration over time (including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max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max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by age and sex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200000"/>
              </a:lnSpc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l Figure 9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3-methoxybenzoic acid-4-sulfate elimination kinetics for cumulative concentration over time (including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max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max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by age and sex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200000"/>
              </a:lnSpc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l Figure 10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Benzoic acid-4-sulfate elimination kinetics for cumulative concentration over time (including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max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max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by age and sex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200000"/>
              </a:lnSpc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l Figure 11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Hippuric acid elimination kinetics for cumulative concentration over time (including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max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max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by age and sex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200000"/>
              </a:lnSpc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l Figure 12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3-hydroxyhippuric acid elimination kinetics for cumulative concentration over time (including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max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max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by age and sex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200000"/>
              </a:lnSpc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l Figure 13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3-methylhippuric acid  elimination kinetics for cumulative concentration over time (including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max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max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by age and sex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2304829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79B643A3-4462-A042-9366-488A9D2C124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37293587"/>
              </p:ext>
            </p:extLst>
          </p:nvPr>
        </p:nvGraphicFramePr>
        <p:xfrm>
          <a:off x="1442233" y="24878"/>
          <a:ext cx="9307534" cy="60716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33BA75C2-A8AB-5147-D6F1-72AD42F5D496}"/>
              </a:ext>
            </a:extLst>
          </p:cNvPr>
          <p:cNvSpPr txBox="1"/>
          <p:nvPr/>
        </p:nvSpPr>
        <p:spPr>
          <a:xfrm>
            <a:off x="1394216" y="5933144"/>
            <a:ext cx="940356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l Figure 9.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3-methoxybenzoic acid-4-sulfate elimination kinetics for cumulative concentration over time (including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max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and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max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 by age and sex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4435785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C86E0357-A5AC-024D-A830-F6AB8874DFB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37423450"/>
              </p:ext>
            </p:extLst>
          </p:nvPr>
        </p:nvGraphicFramePr>
        <p:xfrm>
          <a:off x="1442233" y="12178"/>
          <a:ext cx="9307534" cy="60716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2B3F267F-8C8F-533E-6F31-3D44E7E1EEAC}"/>
              </a:ext>
            </a:extLst>
          </p:cNvPr>
          <p:cNvSpPr txBox="1"/>
          <p:nvPr/>
        </p:nvSpPr>
        <p:spPr>
          <a:xfrm>
            <a:off x="1394216" y="5933144"/>
            <a:ext cx="940356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l Figure 10.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enzoic acid-4-sulfate elimination kinetics for cumulative concentration over time (including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max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and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max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 by age and sex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5136241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72E50E8-0278-F781-B308-B765DF2836C8}"/>
              </a:ext>
            </a:extLst>
          </p:cNvPr>
          <p:cNvSpPr txBox="1"/>
          <p:nvPr/>
        </p:nvSpPr>
        <p:spPr>
          <a:xfrm>
            <a:off x="1394216" y="5933144"/>
            <a:ext cx="940356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l Figure 11.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ippuric acid elimination kinetics for cumulative concentration over time (including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max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and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max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 by age and sex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922A33E1-7008-084D-8EFD-CA79DE88BE5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65017777"/>
              </p:ext>
            </p:extLst>
          </p:nvPr>
        </p:nvGraphicFramePr>
        <p:xfrm>
          <a:off x="1545633" y="107521"/>
          <a:ext cx="9214225" cy="57797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16686724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41AD71D-D55D-1BBA-5AD2-B3BF2536C252}"/>
              </a:ext>
            </a:extLst>
          </p:cNvPr>
          <p:cNvSpPr txBox="1"/>
          <p:nvPr/>
        </p:nvSpPr>
        <p:spPr>
          <a:xfrm>
            <a:off x="1394216" y="5933144"/>
            <a:ext cx="940356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l Figure 12.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3-hydroxyhippuric acid elimination kinetics for cumulative concentration over time (including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max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and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max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 by age and sex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81DCC152-941A-284F-8C3A-D5B59707F73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30336192"/>
              </p:ext>
            </p:extLst>
          </p:nvPr>
        </p:nvGraphicFramePr>
        <p:xfrm>
          <a:off x="1446893" y="399143"/>
          <a:ext cx="9112548" cy="54630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31893568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76D66F8F-03FE-124C-934A-2FD83B0059E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4744391"/>
              </p:ext>
            </p:extLst>
          </p:nvPr>
        </p:nvGraphicFramePr>
        <p:xfrm>
          <a:off x="1442233" y="0"/>
          <a:ext cx="9307534" cy="60716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31B96761-AC47-6E4C-31A6-C9B8B760F8A4}"/>
              </a:ext>
            </a:extLst>
          </p:cNvPr>
          <p:cNvSpPr txBox="1"/>
          <p:nvPr/>
        </p:nvSpPr>
        <p:spPr>
          <a:xfrm>
            <a:off x="1394216" y="5933144"/>
            <a:ext cx="940356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l Figure 13.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3-methylhippuric acid  elimination kinetics for cumulative concentration over time (including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max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and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max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 by age and sex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962327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ECCBC949-FE03-6547-829F-F577C8753C0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57749164"/>
              </p:ext>
            </p:extLst>
          </p:nvPr>
        </p:nvGraphicFramePr>
        <p:xfrm>
          <a:off x="1370314" y="146598"/>
          <a:ext cx="9307534" cy="60716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9AABCADF-B949-9B47-1604-1186D7C978F4}"/>
              </a:ext>
            </a:extLst>
          </p:cNvPr>
          <p:cNvSpPr txBox="1"/>
          <p:nvPr/>
        </p:nvSpPr>
        <p:spPr>
          <a:xfrm>
            <a:off x="1394216" y="5933144"/>
            <a:ext cx="940356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l Figure 1.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aringenin elimination kinetics for cumulative concentration over time (including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max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and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max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 by age and sex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14352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C0728AE3-44CD-0C47-880B-C56FB85358D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58172130"/>
              </p:ext>
            </p:extLst>
          </p:nvPr>
        </p:nvGraphicFramePr>
        <p:xfrm>
          <a:off x="1442233" y="0"/>
          <a:ext cx="9307534" cy="60716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DE068FE3-D17C-4AB4-7844-0A05CD1B80D0}"/>
              </a:ext>
            </a:extLst>
          </p:cNvPr>
          <p:cNvSpPr txBox="1"/>
          <p:nvPr/>
        </p:nvSpPr>
        <p:spPr>
          <a:xfrm>
            <a:off x="1394216" y="5958544"/>
            <a:ext cx="940356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l Figure 2.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aringenin-7-</a:t>
            </a:r>
            <a:r>
              <a:rPr lang="en-GB" sz="1800" i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-glucuronide elimination kinetics for cumulative concentration over time (including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max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and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max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 by age and sex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94603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3729428-8B56-D42C-913E-2BB2F85D8719}"/>
              </a:ext>
            </a:extLst>
          </p:cNvPr>
          <p:cNvSpPr txBox="1"/>
          <p:nvPr/>
        </p:nvSpPr>
        <p:spPr>
          <a:xfrm>
            <a:off x="1394216" y="6070931"/>
            <a:ext cx="940356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l Figure 3. </a:t>
            </a:r>
            <a:r>
              <a:rPr lang="en-GB" dirty="0" smtClean="0">
                <a:latin typeface="Calibri" panose="020F0502020204030204" pitchFamily="34" charset="0"/>
                <a:ea typeface="Calibri" panose="020F0502020204030204" pitchFamily="34" charset="0"/>
              </a:rPr>
              <a:t>(-)-</a:t>
            </a:r>
            <a:r>
              <a:rPr lang="en-GB" sz="1800" dirty="0" err="1" smtClean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picatechin</a:t>
            </a:r>
            <a:r>
              <a:rPr lang="en-GB" sz="18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limination kinetics for cumulative concentration over time (including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max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and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max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 by age and sex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9B91CF2F-8251-224E-91BB-4703185D033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79663305"/>
              </p:ext>
            </p:extLst>
          </p:nvPr>
        </p:nvGraphicFramePr>
        <p:xfrm>
          <a:off x="1554967" y="117606"/>
          <a:ext cx="8941844" cy="60326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556677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C24385AB-B0F4-7142-BF7F-CD89A08C575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58802734"/>
              </p:ext>
            </p:extLst>
          </p:nvPr>
        </p:nvGraphicFramePr>
        <p:xfrm>
          <a:off x="1442233" y="101078"/>
          <a:ext cx="9307534" cy="60716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B0A3D594-2C23-8287-E4AD-487BBEE718E2}"/>
              </a:ext>
            </a:extLst>
          </p:cNvPr>
          <p:cNvSpPr txBox="1"/>
          <p:nvPr/>
        </p:nvSpPr>
        <p:spPr>
          <a:xfrm>
            <a:off x="1394216" y="5933144"/>
            <a:ext cx="940356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l Figure 4.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5-(Hydroxyphenyl)-gamma-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alerolactone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elimination kinetics for cumulative concentration over time (including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max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and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max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 by age and sex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2407036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740FD91-5900-5146-47C1-802995578D37}"/>
              </a:ext>
            </a:extLst>
          </p:cNvPr>
          <p:cNvSpPr txBox="1"/>
          <p:nvPr/>
        </p:nvSpPr>
        <p:spPr>
          <a:xfrm>
            <a:off x="1394216" y="5933144"/>
            <a:ext cx="940356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l Figure 5.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speretin-3'-</a:t>
            </a:r>
            <a:r>
              <a:rPr lang="en-GB" sz="1800" i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-glucuronide elimination kinetics for cumulative concentration over time (including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max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and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max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 by age and sex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7757E436-3A1C-4D41-8752-FD8F3948B65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68359038"/>
              </p:ext>
            </p:extLst>
          </p:nvPr>
        </p:nvGraphicFramePr>
        <p:xfrm>
          <a:off x="1442233" y="393178"/>
          <a:ext cx="8741427" cy="54314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32085804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8D13C341-C152-2E4C-A405-FF6B0115C55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07370437"/>
              </p:ext>
            </p:extLst>
          </p:nvPr>
        </p:nvGraphicFramePr>
        <p:xfrm>
          <a:off x="1442233" y="24878"/>
          <a:ext cx="9307534" cy="60716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EB5F07BC-64C1-0FD1-6920-0DCC094ED6C3}"/>
              </a:ext>
            </a:extLst>
          </p:cNvPr>
          <p:cNvSpPr txBox="1"/>
          <p:nvPr/>
        </p:nvSpPr>
        <p:spPr>
          <a:xfrm>
            <a:off x="1394216" y="5933144"/>
            <a:ext cx="940356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l Figure 6.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speretin-7'-sulfate elimination kinetics for cumulative concentration over time (including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max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and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max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 by age and sex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4207570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2FD3C63A-A1C5-CF46-B7DF-29268483162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64535788"/>
              </p:ext>
            </p:extLst>
          </p:nvPr>
        </p:nvGraphicFramePr>
        <p:xfrm>
          <a:off x="1442233" y="0"/>
          <a:ext cx="9307534" cy="60716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4AE0584C-0B33-E48A-C9C5-7AF8531F6FB9}"/>
              </a:ext>
            </a:extLst>
          </p:cNvPr>
          <p:cNvSpPr txBox="1"/>
          <p:nvPr/>
        </p:nvSpPr>
        <p:spPr>
          <a:xfrm>
            <a:off x="1394216" y="5933144"/>
            <a:ext cx="940356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l Figure 7. </a:t>
            </a:r>
            <a:r>
              <a:rPr lang="en-GB" sz="18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yanidin-3-</a:t>
            </a:r>
            <a:r>
              <a:rPr lang="en-GB" sz="1800" i="1" dirty="0" smtClean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</a:t>
            </a:r>
            <a:r>
              <a:rPr lang="en-GB" sz="18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-glucoside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limination kinetics for cumulative concentration over time (including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max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and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max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 by age and sex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576336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40F9C47-9B78-F82C-F086-7B1ABF6244EA}"/>
              </a:ext>
            </a:extLst>
          </p:cNvPr>
          <p:cNvSpPr txBox="1"/>
          <p:nvPr/>
        </p:nvSpPr>
        <p:spPr>
          <a:xfrm>
            <a:off x="1394216" y="5933144"/>
            <a:ext cx="940356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l Figure 8.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3-hydroxybenzoic acid-4-</a:t>
            </a:r>
            <a:r>
              <a:rPr lang="en-GB" sz="1800" i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-glucuronide elimination kinetics for cumulative concentration over time (including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max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and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max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 by age and sex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513F0410-21F6-114F-8F15-F2C2CA4F3B2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53157461"/>
              </p:ext>
            </p:extLst>
          </p:nvPr>
        </p:nvGraphicFramePr>
        <p:xfrm>
          <a:off x="1592545" y="242866"/>
          <a:ext cx="9004474" cy="56944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242863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085</TotalTime>
  <Words>943</Words>
  <Application>Microsoft Office PowerPoint</Application>
  <PresentationFormat>Widescreen</PresentationFormat>
  <Paragraphs>132</Paragraphs>
  <Slides>1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y Jennings (MED - Staff)</dc:creator>
  <cp:lastModifiedBy>Kay, Colin</cp:lastModifiedBy>
  <cp:revision>11</cp:revision>
  <dcterms:created xsi:type="dcterms:W3CDTF">2022-04-25T15:02:33Z</dcterms:created>
  <dcterms:modified xsi:type="dcterms:W3CDTF">2025-04-23T19:32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8ca390d5-a4f3-448c-8368-24080179bc53_Enabled">
    <vt:lpwstr>true</vt:lpwstr>
  </property>
  <property fmtid="{D5CDD505-2E9C-101B-9397-08002B2CF9AE}" pid="3" name="MSIP_Label_8ca390d5-a4f3-448c-8368-24080179bc53_SetDate">
    <vt:lpwstr>2024-07-28T21:32:49Z</vt:lpwstr>
  </property>
  <property fmtid="{D5CDD505-2E9C-101B-9397-08002B2CF9AE}" pid="4" name="MSIP_Label_8ca390d5-a4f3-448c-8368-24080179bc53_Method">
    <vt:lpwstr>Standard</vt:lpwstr>
  </property>
  <property fmtid="{D5CDD505-2E9C-101B-9397-08002B2CF9AE}" pid="5" name="MSIP_Label_8ca390d5-a4f3-448c-8368-24080179bc53_Name">
    <vt:lpwstr>Low Risk</vt:lpwstr>
  </property>
  <property fmtid="{D5CDD505-2E9C-101B-9397-08002B2CF9AE}" pid="6" name="MSIP_Label_8ca390d5-a4f3-448c-8368-24080179bc53_SiteId">
    <vt:lpwstr>5b703aa0-061f-4ed9-beca-765a39ee1304</vt:lpwstr>
  </property>
  <property fmtid="{D5CDD505-2E9C-101B-9397-08002B2CF9AE}" pid="7" name="MSIP_Label_8ca390d5-a4f3-448c-8368-24080179bc53_ActionId">
    <vt:lpwstr>f5ac4bde-f4d9-4a60-adc3-1b978c19f09e</vt:lpwstr>
  </property>
  <property fmtid="{D5CDD505-2E9C-101B-9397-08002B2CF9AE}" pid="8" name="MSIP_Label_8ca390d5-a4f3-448c-8368-24080179bc53_ContentBits">
    <vt:lpwstr>0</vt:lpwstr>
  </property>
</Properties>
</file>